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docx" ContentType="application/vnd.openxmlformats-officedocument.wordprocessingml.document"/>
  <Default Extension="wdp" ContentType="image/vnd.ms-photo"/>
  <Default Extension="gif" ContentType="image/gi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2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276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24EDE814-E784-4F71-A2DD-7A0B50AED693}" type="doc">
      <dgm:prSet loTypeId="urn:microsoft.com/office/officeart/2005/8/layout/radial2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de-DE"/>
        </a:p>
      </dgm:t>
    </dgm:pt>
    <dgm:pt modelId="{EFE93928-2A4B-49A3-BA0D-35B25864B082}">
      <dgm:prSet phldrT="[Text]" custT="1"/>
      <dgm:spPr>
        <a:solidFill>
          <a:schemeClr val="bg2"/>
        </a:solidFill>
      </dgm:spPr>
      <dgm:t>
        <a:bodyPr/>
        <a:lstStyle/>
        <a:p>
          <a:r>
            <a:rPr lang="de-DE" sz="10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Glucose</a:t>
          </a:r>
          <a:endParaRPr lang="de-DE" sz="1000" dirty="0">
            <a:solidFill>
              <a:schemeClr val="tx1"/>
            </a:solidFill>
            <a:latin typeface="Arial" pitchFamily="34" charset="0"/>
            <a:cs typeface="Arial" pitchFamily="34" charset="0"/>
          </a:endParaRPr>
        </a:p>
      </dgm:t>
    </dgm:pt>
    <dgm:pt modelId="{E3C23CED-2BDF-4ED4-9DFE-963862B7CC42}" type="parTrans" cxnId="{4FC8394F-3730-4C7C-80C0-2906DE90FF14}">
      <dgm:prSet/>
      <dgm:spPr/>
      <dgm:t>
        <a:bodyPr/>
        <a:lstStyle/>
        <a:p>
          <a:endParaRPr lang="de-DE"/>
        </a:p>
      </dgm:t>
    </dgm:pt>
    <dgm:pt modelId="{6DE03961-4B44-4E76-B485-DC1B210E890F}" type="sibTrans" cxnId="{4FC8394F-3730-4C7C-80C0-2906DE90FF14}">
      <dgm:prSet/>
      <dgm:spPr/>
      <dgm:t>
        <a:bodyPr/>
        <a:lstStyle/>
        <a:p>
          <a:endParaRPr lang="de-DE"/>
        </a:p>
      </dgm:t>
    </dgm:pt>
    <dgm:pt modelId="{BB79A4F9-E0F5-46A2-8DCF-D5A74488DE7C}">
      <dgm:prSet phldrT="[Text]" custT="1"/>
      <dgm:spPr/>
      <dgm:t>
        <a:bodyPr/>
        <a:lstStyle/>
        <a:p>
          <a:r>
            <a:rPr lang="de-DE" sz="1000" dirty="0" err="1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Hypoxia</a:t>
          </a:r>
          <a:endParaRPr lang="de-DE" sz="1000" dirty="0">
            <a:solidFill>
              <a:schemeClr val="tx1"/>
            </a:solidFill>
            <a:latin typeface="Arial" pitchFamily="34" charset="0"/>
            <a:cs typeface="Arial" pitchFamily="34" charset="0"/>
          </a:endParaRPr>
        </a:p>
      </dgm:t>
    </dgm:pt>
    <dgm:pt modelId="{006020E3-75C3-493F-B4F0-A254ABAEFE2C}" type="parTrans" cxnId="{9AE34355-98B2-4F9E-8D4C-8CA1E890C9CD}">
      <dgm:prSet/>
      <dgm:spPr/>
      <dgm:t>
        <a:bodyPr/>
        <a:lstStyle/>
        <a:p>
          <a:endParaRPr lang="de-DE"/>
        </a:p>
      </dgm:t>
    </dgm:pt>
    <dgm:pt modelId="{2B391206-F3FE-4702-9F97-07BA788E4ABF}" type="sibTrans" cxnId="{9AE34355-98B2-4F9E-8D4C-8CA1E890C9CD}">
      <dgm:prSet/>
      <dgm:spPr/>
      <dgm:t>
        <a:bodyPr/>
        <a:lstStyle/>
        <a:p>
          <a:endParaRPr lang="de-DE"/>
        </a:p>
      </dgm:t>
    </dgm:pt>
    <dgm:pt modelId="{D93CE672-418D-4AC1-949D-176046F24228}">
      <dgm:prSet phldrT="[Text]" custT="1"/>
      <dgm:spPr>
        <a:solidFill>
          <a:schemeClr val="bg2"/>
        </a:solidFill>
      </dgm:spPr>
      <dgm:t>
        <a:bodyPr/>
        <a:lstStyle/>
        <a:p>
          <a:r>
            <a:rPr lang="de-DE" sz="10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Lack </a:t>
          </a:r>
          <a:r>
            <a:rPr lang="de-DE" sz="1000" dirty="0" err="1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of</a:t>
          </a:r>
          <a:r>
            <a:rPr lang="de-DE" sz="10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 </a:t>
          </a:r>
          <a:r>
            <a:rPr lang="de-DE" sz="1000" dirty="0" err="1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insulin</a:t>
          </a:r>
          <a:endParaRPr lang="de-DE" sz="1000" dirty="0">
            <a:solidFill>
              <a:schemeClr val="tx1"/>
            </a:solidFill>
            <a:latin typeface="Arial" pitchFamily="34" charset="0"/>
            <a:cs typeface="Arial" pitchFamily="34" charset="0"/>
          </a:endParaRPr>
        </a:p>
      </dgm:t>
    </dgm:pt>
    <dgm:pt modelId="{20C7A091-31C2-4EF5-9B4E-1AE6C8A54CEB}" type="parTrans" cxnId="{2C245173-8105-44BF-AFB6-0A7FECEDDD8E}">
      <dgm:prSet/>
      <dgm:spPr/>
      <dgm:t>
        <a:bodyPr/>
        <a:lstStyle/>
        <a:p>
          <a:endParaRPr lang="de-DE"/>
        </a:p>
      </dgm:t>
    </dgm:pt>
    <dgm:pt modelId="{11611D90-5645-49FD-884B-5CF86F9F8D87}" type="sibTrans" cxnId="{2C245173-8105-44BF-AFB6-0A7FECEDDD8E}">
      <dgm:prSet/>
      <dgm:spPr/>
      <dgm:t>
        <a:bodyPr/>
        <a:lstStyle/>
        <a:p>
          <a:endParaRPr lang="de-DE"/>
        </a:p>
      </dgm:t>
    </dgm:pt>
    <dgm:pt modelId="{D5ECAC7A-CFE6-414F-928B-7BD9205569E7}">
      <dgm:prSet custT="1"/>
      <dgm:spPr/>
      <dgm:t>
        <a:bodyPr/>
        <a:lstStyle/>
        <a:p>
          <a:r>
            <a:rPr lang="de-DE" sz="10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H</a:t>
          </a:r>
          <a:r>
            <a:rPr lang="de-DE" sz="1000" baseline="-250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2</a:t>
          </a:r>
          <a:r>
            <a:rPr lang="de-DE" sz="1000" baseline="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O</a:t>
          </a:r>
          <a:r>
            <a:rPr lang="de-DE" sz="1000" baseline="-250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2</a:t>
          </a:r>
          <a:endParaRPr lang="de-DE" sz="1000" dirty="0" smtClean="0">
            <a:solidFill>
              <a:schemeClr val="tx1"/>
            </a:solidFill>
            <a:latin typeface="Arial" pitchFamily="34" charset="0"/>
            <a:cs typeface="Arial" pitchFamily="34" charset="0"/>
          </a:endParaRPr>
        </a:p>
      </dgm:t>
    </dgm:pt>
    <dgm:pt modelId="{13311F8D-3021-4B9A-9D0C-4656E561E91D}" type="parTrans" cxnId="{F6A1C672-68A7-4BDA-AE9C-B1BE91D22D01}">
      <dgm:prSet/>
      <dgm:spPr/>
      <dgm:t>
        <a:bodyPr/>
        <a:lstStyle/>
        <a:p>
          <a:endParaRPr lang="de-DE"/>
        </a:p>
      </dgm:t>
    </dgm:pt>
    <dgm:pt modelId="{8705EE83-3C5F-4865-9C9B-1847024F7C08}" type="sibTrans" cxnId="{F6A1C672-68A7-4BDA-AE9C-B1BE91D22D01}">
      <dgm:prSet/>
      <dgm:spPr/>
      <dgm:t>
        <a:bodyPr/>
        <a:lstStyle/>
        <a:p>
          <a:endParaRPr lang="de-DE"/>
        </a:p>
      </dgm:t>
    </dgm:pt>
    <dgm:pt modelId="{26F91BF7-FAEF-491E-BFFB-F3BDA61A1CBE}" type="pres">
      <dgm:prSet presAssocID="{24EDE814-E784-4F71-A2DD-7A0B50AED693}" presName="composite" presStyleCnt="0">
        <dgm:presLayoutVars>
          <dgm:chMax val="5"/>
          <dgm:dir/>
          <dgm:animLvl val="ctr"/>
          <dgm:resizeHandles val="exact"/>
        </dgm:presLayoutVars>
      </dgm:prSet>
      <dgm:spPr/>
      <dgm:t>
        <a:bodyPr/>
        <a:lstStyle/>
        <a:p>
          <a:endParaRPr lang="de-DE"/>
        </a:p>
      </dgm:t>
    </dgm:pt>
    <dgm:pt modelId="{789E4E55-0D45-46F3-908F-FA80201DC42A}" type="pres">
      <dgm:prSet presAssocID="{24EDE814-E784-4F71-A2DD-7A0B50AED693}" presName="cycle" presStyleCnt="0"/>
      <dgm:spPr/>
    </dgm:pt>
    <dgm:pt modelId="{2A86748B-54F8-4E1F-AEF9-E79F773C881A}" type="pres">
      <dgm:prSet presAssocID="{24EDE814-E784-4F71-A2DD-7A0B50AED693}" presName="centerShape" presStyleCnt="0"/>
      <dgm:spPr/>
    </dgm:pt>
    <dgm:pt modelId="{E60D900A-BC33-4A0A-AFA1-7792CF8AE434}" type="pres">
      <dgm:prSet presAssocID="{24EDE814-E784-4F71-A2DD-7A0B50AED693}" presName="connSite" presStyleLbl="node1" presStyleIdx="0" presStyleCnt="5"/>
      <dgm:spPr/>
    </dgm:pt>
    <dgm:pt modelId="{D629B658-C097-4C2F-8130-EEC5B5301EF6}" type="pres">
      <dgm:prSet presAssocID="{24EDE814-E784-4F71-A2DD-7A0B50AED693}" presName="visible" presStyleLbl="node1" presStyleIdx="0" presStyleCnt="5" custScaleX="85288" custScaleY="88908" custLinFactNeighborX="7277" custLinFactNeighborY="-1197"/>
      <dgm:spPr>
        <a:solidFill>
          <a:schemeClr val="accent2">
            <a:lumMod val="60000"/>
            <a:lumOff val="40000"/>
          </a:schemeClr>
        </a:solidFill>
      </dgm:spPr>
      <dgm:t>
        <a:bodyPr/>
        <a:lstStyle/>
        <a:p>
          <a:endParaRPr lang="de-DE"/>
        </a:p>
      </dgm:t>
    </dgm:pt>
    <dgm:pt modelId="{FB640FBB-2BE9-488D-A07C-F1EB9529A8DE}" type="pres">
      <dgm:prSet presAssocID="{E3C23CED-2BDF-4ED4-9DFE-963862B7CC42}" presName="Name25" presStyleLbl="parChTrans1D1" presStyleIdx="0" presStyleCnt="4"/>
      <dgm:spPr/>
      <dgm:t>
        <a:bodyPr/>
        <a:lstStyle/>
        <a:p>
          <a:endParaRPr lang="de-DE"/>
        </a:p>
      </dgm:t>
    </dgm:pt>
    <dgm:pt modelId="{45E999CA-B44D-454D-8D38-6C69F8FE6660}" type="pres">
      <dgm:prSet presAssocID="{EFE93928-2A4B-49A3-BA0D-35B25864B082}" presName="node" presStyleCnt="0"/>
      <dgm:spPr/>
    </dgm:pt>
    <dgm:pt modelId="{ECEFEB3A-488F-4AA6-9095-794E21A4D47D}" type="pres">
      <dgm:prSet presAssocID="{EFE93928-2A4B-49A3-BA0D-35B25864B082}" presName="parentNode" presStyleLbl="node1" presStyleIdx="1" presStyleCnt="5" custScaleX="88682" custScaleY="89477" custLinFactNeighborX="87759" custLinFactNeighborY="22572">
        <dgm:presLayoutVars>
          <dgm:chMax val="1"/>
          <dgm:bulletEnabled val="1"/>
        </dgm:presLayoutVars>
      </dgm:prSet>
      <dgm:spPr/>
      <dgm:t>
        <a:bodyPr/>
        <a:lstStyle/>
        <a:p>
          <a:endParaRPr lang="de-DE"/>
        </a:p>
      </dgm:t>
    </dgm:pt>
    <dgm:pt modelId="{255E45E5-4B70-4142-B870-D41EC956F29E}" type="pres">
      <dgm:prSet presAssocID="{EFE93928-2A4B-49A3-BA0D-35B25864B082}" presName="childNode" presStyleLbl="revTx" presStyleIdx="0" presStyleCnt="0">
        <dgm:presLayoutVars>
          <dgm:bulletEnabled val="1"/>
        </dgm:presLayoutVars>
      </dgm:prSet>
      <dgm:spPr/>
      <dgm:t>
        <a:bodyPr/>
        <a:lstStyle/>
        <a:p>
          <a:endParaRPr lang="de-DE"/>
        </a:p>
      </dgm:t>
    </dgm:pt>
    <dgm:pt modelId="{A10DC669-52E2-4036-BF72-A5F84FA144D3}" type="pres">
      <dgm:prSet presAssocID="{006020E3-75C3-493F-B4F0-A254ABAEFE2C}" presName="Name25" presStyleLbl="parChTrans1D1" presStyleIdx="1" presStyleCnt="4"/>
      <dgm:spPr/>
      <dgm:t>
        <a:bodyPr/>
        <a:lstStyle/>
        <a:p>
          <a:endParaRPr lang="de-DE"/>
        </a:p>
      </dgm:t>
    </dgm:pt>
    <dgm:pt modelId="{8C0C841E-5ACF-47B3-83CC-60222FC97D92}" type="pres">
      <dgm:prSet presAssocID="{BB79A4F9-E0F5-46A2-8DCF-D5A74488DE7C}" presName="node" presStyleCnt="0"/>
      <dgm:spPr/>
    </dgm:pt>
    <dgm:pt modelId="{1C2A94EA-D297-4FE0-B59C-2184C5AC7178}" type="pres">
      <dgm:prSet presAssocID="{BB79A4F9-E0F5-46A2-8DCF-D5A74488DE7C}" presName="parentNode" presStyleLbl="node1" presStyleIdx="2" presStyleCnt="5" custScaleX="99696" custScaleY="88731" custLinFactNeighborX="31190" custLinFactNeighborY="14182">
        <dgm:presLayoutVars>
          <dgm:chMax val="1"/>
          <dgm:bulletEnabled val="1"/>
        </dgm:presLayoutVars>
      </dgm:prSet>
      <dgm:spPr/>
      <dgm:t>
        <a:bodyPr/>
        <a:lstStyle/>
        <a:p>
          <a:endParaRPr lang="de-DE"/>
        </a:p>
      </dgm:t>
    </dgm:pt>
    <dgm:pt modelId="{160E4B5A-5925-4592-8C81-5A29EF3B0DE8}" type="pres">
      <dgm:prSet presAssocID="{BB79A4F9-E0F5-46A2-8DCF-D5A74488DE7C}" presName="childNode" presStyleLbl="revTx" presStyleIdx="0" presStyleCnt="0">
        <dgm:presLayoutVars>
          <dgm:bulletEnabled val="1"/>
        </dgm:presLayoutVars>
      </dgm:prSet>
      <dgm:spPr/>
      <dgm:t>
        <a:bodyPr/>
        <a:lstStyle/>
        <a:p>
          <a:endParaRPr lang="de-DE"/>
        </a:p>
      </dgm:t>
    </dgm:pt>
    <dgm:pt modelId="{66072639-9301-4CC6-8DE1-4F92756890A3}" type="pres">
      <dgm:prSet presAssocID="{20C7A091-31C2-4EF5-9B4E-1AE6C8A54CEB}" presName="Name25" presStyleLbl="parChTrans1D1" presStyleIdx="2" presStyleCnt="4"/>
      <dgm:spPr/>
      <dgm:t>
        <a:bodyPr/>
        <a:lstStyle/>
        <a:p>
          <a:endParaRPr lang="de-DE"/>
        </a:p>
      </dgm:t>
    </dgm:pt>
    <dgm:pt modelId="{81006C44-0291-401A-8A38-53E12C2B3B04}" type="pres">
      <dgm:prSet presAssocID="{D93CE672-418D-4AC1-949D-176046F24228}" presName="node" presStyleCnt="0"/>
      <dgm:spPr/>
    </dgm:pt>
    <dgm:pt modelId="{BF0BA5FD-1F06-48CC-B73E-224283DD9F95}" type="pres">
      <dgm:prSet presAssocID="{D93CE672-418D-4AC1-949D-176046F24228}" presName="parentNode" presStyleLbl="node1" presStyleIdx="3" presStyleCnt="5" custScaleX="90661" custScaleY="88109" custLinFactNeighborX="36802" custLinFactNeighborY="-10469">
        <dgm:presLayoutVars>
          <dgm:chMax val="1"/>
          <dgm:bulletEnabled val="1"/>
        </dgm:presLayoutVars>
      </dgm:prSet>
      <dgm:spPr/>
      <dgm:t>
        <a:bodyPr/>
        <a:lstStyle/>
        <a:p>
          <a:endParaRPr lang="de-DE"/>
        </a:p>
      </dgm:t>
    </dgm:pt>
    <dgm:pt modelId="{CF13492B-FAC1-447B-89B4-290A6CB8141A}" type="pres">
      <dgm:prSet presAssocID="{D93CE672-418D-4AC1-949D-176046F24228}" presName="childNode" presStyleLbl="revTx" presStyleIdx="0" presStyleCnt="0">
        <dgm:presLayoutVars>
          <dgm:bulletEnabled val="1"/>
        </dgm:presLayoutVars>
      </dgm:prSet>
      <dgm:spPr/>
      <dgm:t>
        <a:bodyPr/>
        <a:lstStyle/>
        <a:p>
          <a:endParaRPr lang="de-DE"/>
        </a:p>
      </dgm:t>
    </dgm:pt>
    <dgm:pt modelId="{BF0F1D9E-9712-4CEB-B388-242078F94B91}" type="pres">
      <dgm:prSet presAssocID="{13311F8D-3021-4B9A-9D0C-4656E561E91D}" presName="Name25" presStyleLbl="parChTrans1D1" presStyleIdx="3" presStyleCnt="4"/>
      <dgm:spPr/>
      <dgm:t>
        <a:bodyPr/>
        <a:lstStyle/>
        <a:p>
          <a:endParaRPr lang="de-DE"/>
        </a:p>
      </dgm:t>
    </dgm:pt>
    <dgm:pt modelId="{C15CCFA5-4D4C-4DEC-A759-F9716944F10F}" type="pres">
      <dgm:prSet presAssocID="{D5ECAC7A-CFE6-414F-928B-7BD9205569E7}" presName="node" presStyleCnt="0"/>
      <dgm:spPr/>
    </dgm:pt>
    <dgm:pt modelId="{97711ABF-6BE2-4A6D-ABB3-BE9384CC4344}" type="pres">
      <dgm:prSet presAssocID="{D5ECAC7A-CFE6-414F-928B-7BD9205569E7}" presName="parentNode" presStyleLbl="node1" presStyleIdx="4" presStyleCnt="5" custScaleX="107658" custScaleY="97002" custLinFactNeighborX="41945" custLinFactNeighborY="-39699">
        <dgm:presLayoutVars>
          <dgm:chMax val="1"/>
          <dgm:bulletEnabled val="1"/>
        </dgm:presLayoutVars>
      </dgm:prSet>
      <dgm:spPr/>
      <dgm:t>
        <a:bodyPr/>
        <a:lstStyle/>
        <a:p>
          <a:endParaRPr lang="de-DE"/>
        </a:p>
      </dgm:t>
    </dgm:pt>
    <dgm:pt modelId="{02070EBD-9D8D-4E48-8036-2EFFE71796C4}" type="pres">
      <dgm:prSet presAssocID="{D5ECAC7A-CFE6-414F-928B-7BD9205569E7}" presName="childNode" presStyleLbl="revTx" presStyleIdx="0" presStyleCnt="0">
        <dgm:presLayoutVars>
          <dgm:bulletEnabled val="1"/>
        </dgm:presLayoutVars>
      </dgm:prSet>
      <dgm:spPr/>
    </dgm:pt>
  </dgm:ptLst>
  <dgm:cxnLst>
    <dgm:cxn modelId="{2C245173-8105-44BF-AFB6-0A7FECEDDD8E}" srcId="{24EDE814-E784-4F71-A2DD-7A0B50AED693}" destId="{D93CE672-418D-4AC1-949D-176046F24228}" srcOrd="2" destOrd="0" parTransId="{20C7A091-31C2-4EF5-9B4E-1AE6C8A54CEB}" sibTransId="{11611D90-5645-49FD-884B-5CF86F9F8D87}"/>
    <dgm:cxn modelId="{5BA67831-67E9-4DAE-BE75-32F9199A44C5}" type="presOf" srcId="{20C7A091-31C2-4EF5-9B4E-1AE6C8A54CEB}" destId="{66072639-9301-4CC6-8DE1-4F92756890A3}" srcOrd="0" destOrd="0" presId="urn:microsoft.com/office/officeart/2005/8/layout/radial2"/>
    <dgm:cxn modelId="{7A70B7A7-BFCD-429E-B1BC-3D24F6D21015}" type="presOf" srcId="{E3C23CED-2BDF-4ED4-9DFE-963862B7CC42}" destId="{FB640FBB-2BE9-488D-A07C-F1EB9529A8DE}" srcOrd="0" destOrd="0" presId="urn:microsoft.com/office/officeart/2005/8/layout/radial2"/>
    <dgm:cxn modelId="{4FC8394F-3730-4C7C-80C0-2906DE90FF14}" srcId="{24EDE814-E784-4F71-A2DD-7A0B50AED693}" destId="{EFE93928-2A4B-49A3-BA0D-35B25864B082}" srcOrd="0" destOrd="0" parTransId="{E3C23CED-2BDF-4ED4-9DFE-963862B7CC42}" sibTransId="{6DE03961-4B44-4E76-B485-DC1B210E890F}"/>
    <dgm:cxn modelId="{B398217D-AC12-4E1E-B0B5-BEBC1739FAB9}" type="presOf" srcId="{D5ECAC7A-CFE6-414F-928B-7BD9205569E7}" destId="{97711ABF-6BE2-4A6D-ABB3-BE9384CC4344}" srcOrd="0" destOrd="0" presId="urn:microsoft.com/office/officeart/2005/8/layout/radial2"/>
    <dgm:cxn modelId="{A076E0EC-20C4-4ED7-9E4A-BF3E9E90609B}" type="presOf" srcId="{006020E3-75C3-493F-B4F0-A254ABAEFE2C}" destId="{A10DC669-52E2-4036-BF72-A5F84FA144D3}" srcOrd="0" destOrd="0" presId="urn:microsoft.com/office/officeart/2005/8/layout/radial2"/>
    <dgm:cxn modelId="{9AE34355-98B2-4F9E-8D4C-8CA1E890C9CD}" srcId="{24EDE814-E784-4F71-A2DD-7A0B50AED693}" destId="{BB79A4F9-E0F5-46A2-8DCF-D5A74488DE7C}" srcOrd="1" destOrd="0" parTransId="{006020E3-75C3-493F-B4F0-A254ABAEFE2C}" sibTransId="{2B391206-F3FE-4702-9F97-07BA788E4ABF}"/>
    <dgm:cxn modelId="{CD75220F-0EF4-4782-8F7B-DF1538296853}" type="presOf" srcId="{EFE93928-2A4B-49A3-BA0D-35B25864B082}" destId="{ECEFEB3A-488F-4AA6-9095-794E21A4D47D}" srcOrd="0" destOrd="0" presId="urn:microsoft.com/office/officeart/2005/8/layout/radial2"/>
    <dgm:cxn modelId="{F6A1C672-68A7-4BDA-AE9C-B1BE91D22D01}" srcId="{24EDE814-E784-4F71-A2DD-7A0B50AED693}" destId="{D5ECAC7A-CFE6-414F-928B-7BD9205569E7}" srcOrd="3" destOrd="0" parTransId="{13311F8D-3021-4B9A-9D0C-4656E561E91D}" sibTransId="{8705EE83-3C5F-4865-9C9B-1847024F7C08}"/>
    <dgm:cxn modelId="{3A4522C7-D5D1-4667-B715-4C3A5373C5D6}" type="presOf" srcId="{BB79A4F9-E0F5-46A2-8DCF-D5A74488DE7C}" destId="{1C2A94EA-D297-4FE0-B59C-2184C5AC7178}" srcOrd="0" destOrd="0" presId="urn:microsoft.com/office/officeart/2005/8/layout/radial2"/>
    <dgm:cxn modelId="{5328795C-1C27-49D7-8D72-27D83DB8184C}" type="presOf" srcId="{D93CE672-418D-4AC1-949D-176046F24228}" destId="{BF0BA5FD-1F06-48CC-B73E-224283DD9F95}" srcOrd="0" destOrd="0" presId="urn:microsoft.com/office/officeart/2005/8/layout/radial2"/>
    <dgm:cxn modelId="{639C58FE-98B9-4200-B949-F08F5F3B89D1}" type="presOf" srcId="{24EDE814-E784-4F71-A2DD-7A0B50AED693}" destId="{26F91BF7-FAEF-491E-BFFB-F3BDA61A1CBE}" srcOrd="0" destOrd="0" presId="urn:microsoft.com/office/officeart/2005/8/layout/radial2"/>
    <dgm:cxn modelId="{65A67119-04A3-4BD4-8F8A-00B84CBC0DF8}" type="presOf" srcId="{13311F8D-3021-4B9A-9D0C-4656E561E91D}" destId="{BF0F1D9E-9712-4CEB-B388-242078F94B91}" srcOrd="0" destOrd="0" presId="urn:microsoft.com/office/officeart/2005/8/layout/radial2"/>
    <dgm:cxn modelId="{09692427-AE52-4F4E-BE96-6806397D78A5}" type="presParOf" srcId="{26F91BF7-FAEF-491E-BFFB-F3BDA61A1CBE}" destId="{789E4E55-0D45-46F3-908F-FA80201DC42A}" srcOrd="0" destOrd="0" presId="urn:microsoft.com/office/officeart/2005/8/layout/radial2"/>
    <dgm:cxn modelId="{AE133B94-8C0C-4AA9-9E5F-224B1F7104B4}" type="presParOf" srcId="{789E4E55-0D45-46F3-908F-FA80201DC42A}" destId="{2A86748B-54F8-4E1F-AEF9-E79F773C881A}" srcOrd="0" destOrd="0" presId="urn:microsoft.com/office/officeart/2005/8/layout/radial2"/>
    <dgm:cxn modelId="{9E28DFC9-DD4A-4D84-A07A-C4F01BF6D65A}" type="presParOf" srcId="{2A86748B-54F8-4E1F-AEF9-E79F773C881A}" destId="{E60D900A-BC33-4A0A-AFA1-7792CF8AE434}" srcOrd="0" destOrd="0" presId="urn:microsoft.com/office/officeart/2005/8/layout/radial2"/>
    <dgm:cxn modelId="{5616DCB0-8C07-4D37-8BE1-9730F1BAEA2C}" type="presParOf" srcId="{2A86748B-54F8-4E1F-AEF9-E79F773C881A}" destId="{D629B658-C097-4C2F-8130-EEC5B5301EF6}" srcOrd="1" destOrd="0" presId="urn:microsoft.com/office/officeart/2005/8/layout/radial2"/>
    <dgm:cxn modelId="{2EB72CAA-15AB-40C2-ADEF-18F1A00010FF}" type="presParOf" srcId="{789E4E55-0D45-46F3-908F-FA80201DC42A}" destId="{FB640FBB-2BE9-488D-A07C-F1EB9529A8DE}" srcOrd="1" destOrd="0" presId="urn:microsoft.com/office/officeart/2005/8/layout/radial2"/>
    <dgm:cxn modelId="{9E176897-7AC7-43F4-A828-7F1A8538E62A}" type="presParOf" srcId="{789E4E55-0D45-46F3-908F-FA80201DC42A}" destId="{45E999CA-B44D-454D-8D38-6C69F8FE6660}" srcOrd="2" destOrd="0" presId="urn:microsoft.com/office/officeart/2005/8/layout/radial2"/>
    <dgm:cxn modelId="{79765A71-F94C-4632-8690-C2D8958DD478}" type="presParOf" srcId="{45E999CA-B44D-454D-8D38-6C69F8FE6660}" destId="{ECEFEB3A-488F-4AA6-9095-794E21A4D47D}" srcOrd="0" destOrd="0" presId="urn:microsoft.com/office/officeart/2005/8/layout/radial2"/>
    <dgm:cxn modelId="{5F7F0547-0389-4338-B269-100F210D9528}" type="presParOf" srcId="{45E999CA-B44D-454D-8D38-6C69F8FE6660}" destId="{255E45E5-4B70-4142-B870-D41EC956F29E}" srcOrd="1" destOrd="0" presId="urn:microsoft.com/office/officeart/2005/8/layout/radial2"/>
    <dgm:cxn modelId="{B492056D-2FD0-405D-BE6A-86D1C596ADA2}" type="presParOf" srcId="{789E4E55-0D45-46F3-908F-FA80201DC42A}" destId="{A10DC669-52E2-4036-BF72-A5F84FA144D3}" srcOrd="3" destOrd="0" presId="urn:microsoft.com/office/officeart/2005/8/layout/radial2"/>
    <dgm:cxn modelId="{FA0B6503-7648-4234-8E91-8FDBA191355A}" type="presParOf" srcId="{789E4E55-0D45-46F3-908F-FA80201DC42A}" destId="{8C0C841E-5ACF-47B3-83CC-60222FC97D92}" srcOrd="4" destOrd="0" presId="urn:microsoft.com/office/officeart/2005/8/layout/radial2"/>
    <dgm:cxn modelId="{9D8D5126-6C96-4FB7-BBEF-F0E0F343A5C6}" type="presParOf" srcId="{8C0C841E-5ACF-47B3-83CC-60222FC97D92}" destId="{1C2A94EA-D297-4FE0-B59C-2184C5AC7178}" srcOrd="0" destOrd="0" presId="urn:microsoft.com/office/officeart/2005/8/layout/radial2"/>
    <dgm:cxn modelId="{25FFC536-11DC-4F9D-A417-EEF8501CF741}" type="presParOf" srcId="{8C0C841E-5ACF-47B3-83CC-60222FC97D92}" destId="{160E4B5A-5925-4592-8C81-5A29EF3B0DE8}" srcOrd="1" destOrd="0" presId="urn:microsoft.com/office/officeart/2005/8/layout/radial2"/>
    <dgm:cxn modelId="{2310A14F-0C10-41CF-8B90-FD6CEDE61348}" type="presParOf" srcId="{789E4E55-0D45-46F3-908F-FA80201DC42A}" destId="{66072639-9301-4CC6-8DE1-4F92756890A3}" srcOrd="5" destOrd="0" presId="urn:microsoft.com/office/officeart/2005/8/layout/radial2"/>
    <dgm:cxn modelId="{620C2157-497C-4A3C-B1BA-2A3E785EEA3F}" type="presParOf" srcId="{789E4E55-0D45-46F3-908F-FA80201DC42A}" destId="{81006C44-0291-401A-8A38-53E12C2B3B04}" srcOrd="6" destOrd="0" presId="urn:microsoft.com/office/officeart/2005/8/layout/radial2"/>
    <dgm:cxn modelId="{2DFD0BBB-517E-4C9D-B26C-E85A099BA88B}" type="presParOf" srcId="{81006C44-0291-401A-8A38-53E12C2B3B04}" destId="{BF0BA5FD-1F06-48CC-B73E-224283DD9F95}" srcOrd="0" destOrd="0" presId="urn:microsoft.com/office/officeart/2005/8/layout/radial2"/>
    <dgm:cxn modelId="{ABD4156A-4470-44C9-B70C-C1DA26BC872D}" type="presParOf" srcId="{81006C44-0291-401A-8A38-53E12C2B3B04}" destId="{CF13492B-FAC1-447B-89B4-290A6CB8141A}" srcOrd="1" destOrd="0" presId="urn:microsoft.com/office/officeart/2005/8/layout/radial2"/>
    <dgm:cxn modelId="{B7D2F9FF-19EA-4F81-8B81-14C9D567DFB2}" type="presParOf" srcId="{789E4E55-0D45-46F3-908F-FA80201DC42A}" destId="{BF0F1D9E-9712-4CEB-B388-242078F94B91}" srcOrd="7" destOrd="0" presId="urn:microsoft.com/office/officeart/2005/8/layout/radial2"/>
    <dgm:cxn modelId="{0DC391F6-C802-4171-93B4-2D67563A3948}" type="presParOf" srcId="{789E4E55-0D45-46F3-908F-FA80201DC42A}" destId="{C15CCFA5-4D4C-4DEC-A759-F9716944F10F}" srcOrd="8" destOrd="0" presId="urn:microsoft.com/office/officeart/2005/8/layout/radial2"/>
    <dgm:cxn modelId="{3DBD524F-BB4E-4987-9B82-75E83725C7EC}" type="presParOf" srcId="{C15CCFA5-4D4C-4DEC-A759-F9716944F10F}" destId="{97711ABF-6BE2-4A6D-ABB3-BE9384CC4344}" srcOrd="0" destOrd="0" presId="urn:microsoft.com/office/officeart/2005/8/layout/radial2"/>
    <dgm:cxn modelId="{C32FFF55-9CBB-4306-9CDD-8055126C5A10}" type="presParOf" srcId="{C15CCFA5-4D4C-4DEC-A759-F9716944F10F}" destId="{02070EBD-9D8D-4E48-8036-2EFFE71796C4}" srcOrd="1" destOrd="0" presId="urn:microsoft.com/office/officeart/2005/8/layout/radial2"/>
  </dgm:cxnLst>
  <dgm:bg/>
  <dgm:whole/>
  <dgm:extLst>
    <a:ext uri="http://schemas.microsoft.com/office/drawing/2008/diagram">
      <dsp:dataModelExt xmlns:dsp="http://schemas.microsoft.com/office/drawing/2008/diagram" relId="rId14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BF0F1D9E-9712-4CEB-B388-242078F94B91}">
      <dsp:nvSpPr>
        <dsp:cNvPr id="0" name=""/>
        <dsp:cNvSpPr/>
      </dsp:nvSpPr>
      <dsp:spPr>
        <a:xfrm rot="2691370">
          <a:off x="2917268" y="3044942"/>
          <a:ext cx="607142" cy="38540"/>
        </a:xfrm>
        <a:custGeom>
          <a:avLst/>
          <a:gdLst/>
          <a:ahLst/>
          <a:cxnLst/>
          <a:rect l="0" t="0" r="0" b="0"/>
          <a:pathLst>
            <a:path>
              <a:moveTo>
                <a:pt x="0" y="19270"/>
              </a:moveTo>
              <a:lnTo>
                <a:pt x="607142" y="19270"/>
              </a:lnTo>
            </a:path>
          </a:pathLst>
        </a:custGeom>
        <a:noFill/>
        <a:ln w="127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66072639-9301-4CC6-8DE1-4F92756890A3}">
      <dsp:nvSpPr>
        <dsp:cNvPr id="0" name=""/>
        <dsp:cNvSpPr/>
      </dsp:nvSpPr>
      <dsp:spPr>
        <a:xfrm rot="912798">
          <a:off x="2987948" y="2537743"/>
          <a:ext cx="1009944" cy="38540"/>
        </a:xfrm>
        <a:custGeom>
          <a:avLst/>
          <a:gdLst/>
          <a:ahLst/>
          <a:cxnLst/>
          <a:rect l="0" t="0" r="0" b="0"/>
          <a:pathLst>
            <a:path>
              <a:moveTo>
                <a:pt x="0" y="19270"/>
              </a:moveTo>
              <a:lnTo>
                <a:pt x="1009944" y="19270"/>
              </a:lnTo>
            </a:path>
          </a:pathLst>
        </a:custGeom>
        <a:noFill/>
        <a:ln w="127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10DC669-52E2-4036-BF72-A5F84FA144D3}">
      <dsp:nvSpPr>
        <dsp:cNvPr id="0" name=""/>
        <dsp:cNvSpPr/>
      </dsp:nvSpPr>
      <dsp:spPr>
        <a:xfrm rot="20718647">
          <a:off x="2991039" y="1977550"/>
          <a:ext cx="893729" cy="38540"/>
        </a:xfrm>
        <a:custGeom>
          <a:avLst/>
          <a:gdLst/>
          <a:ahLst/>
          <a:cxnLst/>
          <a:rect l="0" t="0" r="0" b="0"/>
          <a:pathLst>
            <a:path>
              <a:moveTo>
                <a:pt x="0" y="19270"/>
              </a:moveTo>
              <a:lnTo>
                <a:pt x="893729" y="19270"/>
              </a:lnTo>
            </a:path>
          </a:pathLst>
        </a:custGeom>
        <a:noFill/>
        <a:ln w="127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B640FBB-2BE9-488D-A07C-F1EB9529A8DE}">
      <dsp:nvSpPr>
        <dsp:cNvPr id="0" name=""/>
        <dsp:cNvSpPr/>
      </dsp:nvSpPr>
      <dsp:spPr>
        <a:xfrm rot="19221121">
          <a:off x="2865919" y="1369800"/>
          <a:ext cx="1214896" cy="38540"/>
        </a:xfrm>
        <a:custGeom>
          <a:avLst/>
          <a:gdLst/>
          <a:ahLst/>
          <a:cxnLst/>
          <a:rect l="0" t="0" r="0" b="0"/>
          <a:pathLst>
            <a:path>
              <a:moveTo>
                <a:pt x="0" y="19270"/>
              </a:moveTo>
              <a:lnTo>
                <a:pt x="1214896" y="19270"/>
              </a:lnTo>
            </a:path>
          </a:pathLst>
        </a:custGeom>
        <a:noFill/>
        <a:ln w="127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629B658-C097-4C2F-8130-EEC5B5301EF6}">
      <dsp:nvSpPr>
        <dsp:cNvPr id="0" name=""/>
        <dsp:cNvSpPr/>
      </dsp:nvSpPr>
      <dsp:spPr>
        <a:xfrm>
          <a:off x="1822256" y="1496704"/>
          <a:ext cx="1434320" cy="1495199"/>
        </a:xfrm>
        <a:prstGeom prst="ellipse">
          <a:avLst/>
        </a:prstGeom>
        <a:solidFill>
          <a:schemeClr val="accent2">
            <a:lumMod val="60000"/>
            <a:lumOff val="4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ECEFEB3A-488F-4AA6-9095-794E21A4D47D}">
      <dsp:nvSpPr>
        <dsp:cNvPr id="0" name=""/>
        <dsp:cNvSpPr/>
      </dsp:nvSpPr>
      <dsp:spPr>
        <a:xfrm>
          <a:off x="3839420" y="263527"/>
          <a:ext cx="894839" cy="902861"/>
        </a:xfrm>
        <a:prstGeom prst="ellipse">
          <a:avLst/>
        </a:prstGeom>
        <a:solidFill>
          <a:schemeClr val="bg2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de-DE" sz="1000" kern="12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Glucose</a:t>
          </a:r>
          <a:endParaRPr lang="de-DE" sz="1000" kern="1200" dirty="0">
            <a:solidFill>
              <a:schemeClr val="tx1"/>
            </a:solidFill>
            <a:latin typeface="Arial" pitchFamily="34" charset="0"/>
            <a:cs typeface="Arial" pitchFamily="34" charset="0"/>
          </a:endParaRPr>
        </a:p>
      </dsp:txBody>
      <dsp:txXfrm>
        <a:off x="3970466" y="395748"/>
        <a:ext cx="632747" cy="638419"/>
      </dsp:txXfrm>
    </dsp:sp>
    <dsp:sp modelId="{1C2A94EA-D297-4FE0-B59C-2184C5AC7178}">
      <dsp:nvSpPr>
        <dsp:cNvPr id="0" name=""/>
        <dsp:cNvSpPr/>
      </dsp:nvSpPr>
      <dsp:spPr>
        <a:xfrm>
          <a:off x="3849669" y="1309356"/>
          <a:ext cx="1005975" cy="895333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de-DE" sz="1000" kern="1200" dirty="0" err="1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Hypoxia</a:t>
          </a:r>
          <a:endParaRPr lang="de-DE" sz="1000" kern="1200" dirty="0">
            <a:solidFill>
              <a:schemeClr val="tx1"/>
            </a:solidFill>
            <a:latin typeface="Arial" pitchFamily="34" charset="0"/>
            <a:cs typeface="Arial" pitchFamily="34" charset="0"/>
          </a:endParaRPr>
        </a:p>
      </dsp:txBody>
      <dsp:txXfrm>
        <a:off x="3996991" y="1440474"/>
        <a:ext cx="711331" cy="633097"/>
      </dsp:txXfrm>
    </dsp:sp>
    <dsp:sp modelId="{BF0BA5FD-1F06-48CC-B73E-224283DD9F95}">
      <dsp:nvSpPr>
        <dsp:cNvPr id="0" name=""/>
        <dsp:cNvSpPr/>
      </dsp:nvSpPr>
      <dsp:spPr>
        <a:xfrm>
          <a:off x="3963276" y="2364782"/>
          <a:ext cx="914808" cy="889057"/>
        </a:xfrm>
        <a:prstGeom prst="ellipse">
          <a:avLst/>
        </a:prstGeom>
        <a:solidFill>
          <a:schemeClr val="bg2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de-DE" sz="1000" kern="12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Lack </a:t>
          </a:r>
          <a:r>
            <a:rPr lang="de-DE" sz="1000" kern="1200" dirty="0" err="1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of</a:t>
          </a:r>
          <a:r>
            <a:rPr lang="de-DE" sz="1000" kern="12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 </a:t>
          </a:r>
          <a:r>
            <a:rPr lang="de-DE" sz="1000" kern="1200" dirty="0" err="1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insulin</a:t>
          </a:r>
          <a:endParaRPr lang="de-DE" sz="1000" kern="1200" dirty="0">
            <a:solidFill>
              <a:schemeClr val="tx1"/>
            </a:solidFill>
            <a:latin typeface="Arial" pitchFamily="34" charset="0"/>
            <a:cs typeface="Arial" pitchFamily="34" charset="0"/>
          </a:endParaRPr>
        </a:p>
      </dsp:txBody>
      <dsp:txXfrm>
        <a:off x="4097247" y="2494981"/>
        <a:ext cx="646866" cy="628659"/>
      </dsp:txXfrm>
    </dsp:sp>
    <dsp:sp modelId="{97711ABF-6BE2-4A6D-ABB3-BE9384CC4344}">
      <dsp:nvSpPr>
        <dsp:cNvPr id="0" name=""/>
        <dsp:cNvSpPr/>
      </dsp:nvSpPr>
      <dsp:spPr>
        <a:xfrm>
          <a:off x="3257465" y="3151695"/>
          <a:ext cx="1086315" cy="978791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de-DE" sz="1000" kern="12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H</a:t>
          </a:r>
          <a:r>
            <a:rPr lang="de-DE" sz="1000" kern="1200" baseline="-250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2</a:t>
          </a:r>
          <a:r>
            <a:rPr lang="de-DE" sz="1000" kern="1200" baseline="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O</a:t>
          </a:r>
          <a:r>
            <a:rPr lang="de-DE" sz="1000" kern="1200" baseline="-250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rPr>
            <a:t>2</a:t>
          </a:r>
          <a:endParaRPr lang="de-DE" sz="1000" kern="1200" dirty="0" smtClean="0">
            <a:solidFill>
              <a:schemeClr val="tx1"/>
            </a:solidFill>
            <a:latin typeface="Arial" pitchFamily="34" charset="0"/>
            <a:cs typeface="Arial" pitchFamily="34" charset="0"/>
          </a:endParaRPr>
        </a:p>
      </dsp:txBody>
      <dsp:txXfrm>
        <a:off x="3416552" y="3295036"/>
        <a:ext cx="768141" cy="692109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radial2">
  <dgm:title val=""/>
  <dgm:desc val=""/>
  <dgm:catLst>
    <dgm:cat type="relationship" pri="20000"/>
    <dgm:cat type="convert" pri="9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composite">
    <dgm:varLst>
      <dgm:chMax val="5"/>
      <dgm:dir/>
      <dgm:animLvl val="ctr"/>
      <dgm:resizeHandles val="exact"/>
    </dgm:varLst>
    <dgm:alg type="composite"/>
    <dgm:shape xmlns:r="http://schemas.openxmlformats.org/officeDocument/2006/relationships" r:blip="">
      <dgm:adjLst/>
    </dgm:shape>
    <dgm:presOf/>
    <dgm:constrLst>
      <dgm:constr type="w" for="ch" forName="cycle" refType="w"/>
      <dgm:constr type="h" for="ch" forName="cycle" refType="h"/>
    </dgm:constrLst>
    <dgm:ruleLst/>
    <dgm:layoutNode name="cycle">
      <dgm:choose name="Name0">
        <dgm:if name="Name1" func="var" arg="dir" op="equ" val="norm">
          <dgm:choose name="Name2">
            <dgm:if name="Name3" axis="ch" ptType="node" func="cnt" op="lte" val="1">
              <dgm:alg type="cycle">
                <dgm:param type="stAng" val="90"/>
                <dgm:param type="spanAng" val="360"/>
                <dgm:param type="ctrShpMap" val="fNode"/>
              </dgm:alg>
            </dgm:if>
            <dgm:if name="Name4" axis="ch" ptType="node" func="cnt" op="equ" val="2">
              <dgm:alg type="cycle">
                <dgm:param type="stAng" val="70"/>
                <dgm:param type="spanAng" val="40"/>
                <dgm:param type="ctrShpMap" val="fNode"/>
              </dgm:alg>
            </dgm:if>
            <dgm:if name="Name5" axis="ch" ptType="node" func="cnt" op="equ" val="3">
              <dgm:alg type="cycle">
                <dgm:param type="stAng" val="60"/>
                <dgm:param type="spanAng" val="60"/>
                <dgm:param type="ctrShpMap" val="fNode"/>
              </dgm:alg>
            </dgm:if>
            <dgm:else name="Name6">
              <dgm:alg type="cycle">
                <dgm:param type="stAng" val="45"/>
                <dgm:param type="spanAng" val="90"/>
                <dgm:param type="ctrShpMap" val="fNode"/>
              </dgm:alg>
            </dgm:else>
          </dgm:choose>
        </dgm:if>
        <dgm:else name="Name7">
          <dgm:choose name="Name8">
            <dgm:if name="Name9" axis="ch" ptType="node" func="cnt" op="lte" val="1">
              <dgm:alg type="cycle">
                <dgm:param type="stAng" val="-90"/>
                <dgm:param type="spanAng" val="-360"/>
                <dgm:param type="ctrShpMap" val="fNode"/>
              </dgm:alg>
            </dgm:if>
            <dgm:if name="Name10" axis="ch" ptType="node" func="cnt" op="equ" val="2">
              <dgm:alg type="cycle">
                <dgm:param type="stAng" val="-70"/>
                <dgm:param type="spanAng" val="-40"/>
                <dgm:param type="ctrShpMap" val="fNode"/>
              </dgm:alg>
            </dgm:if>
            <dgm:if name="Name11" axis="ch" ptType="node" func="cnt" op="equ" val="3">
              <dgm:alg type="cycle">
                <dgm:param type="stAng" val="-60"/>
                <dgm:param type="spanAng" val="-60"/>
                <dgm:param type="ctrShpMap" val="fNode"/>
              </dgm:alg>
            </dgm:if>
            <dgm:else name="Name12">
              <dgm:alg type="cycle">
                <dgm:param type="stAng" val="-45"/>
                <dgm:param type="spanAng" val="-90"/>
                <dgm:param type="ctrShpMap" val="fNode"/>
              </dgm:alg>
            </dgm:else>
          </dgm:choose>
        </dgm:else>
      </dgm:choose>
      <dgm:shape xmlns:r="http://schemas.openxmlformats.org/officeDocument/2006/relationships" r:blip="">
        <dgm:adjLst/>
      </dgm:shape>
      <dgm:presOf/>
      <dgm:constrLst>
        <dgm:constr type="sp" val="20"/>
        <dgm:constr type="w" for="ch" forName="centerShape" refType="w"/>
        <dgm:constr type="w" for="ch" forName="node" refType="w" refFor="ch" refForName="centerShape" fact="1.5"/>
        <dgm:constr type="sibSp" refType="w" refFor="ch" refForName="centerShape" op="equ" fact="0.08"/>
        <dgm:constr type="primFontSz" for="des" forName="parentNode" op="equ" val="65"/>
        <dgm:constr type="secFontSz" for="des" forName="childNode" op="equ" val="65"/>
      </dgm:constrLst>
      <dgm:ruleLst/>
      <dgm:choose name="Name13">
        <dgm:if name="Name14" axis="ch" ptType="node" hideLastTrans="0" func="cnt" op="gte" val="1">
          <dgm:layoutNode name="centerShape" styleLbl="node0">
            <dgm:alg type="composite"/>
            <dgm:shape xmlns:r="http://schemas.openxmlformats.org/officeDocument/2006/relationships" r:blip="">
              <dgm:adjLst/>
            </dgm:shape>
            <dgm:presOf axis="ch" ptType="node" cnt="1"/>
            <dgm:constrLst>
              <dgm:constr type="w" for="ch" forName="connSite" refType="w" fact="0.7"/>
              <dgm:constr type="h" for="ch" forName="connSite" refType="w" fact="0.7"/>
              <dgm:constr type="ctrX" for="ch" forName="connSite" refType="w" fact="0.5"/>
              <dgm:constr type="ctrY" for="ch" forName="connSite" refType="h" fact="0.5"/>
              <dgm:constr type="w" for="ch" forName="visible" refType="w"/>
              <dgm:constr type="h" for="ch" forName="visible" refType="w"/>
              <dgm:constr type="ctrX" for="ch" forName="visible" refType="w" fact="0.5"/>
              <dgm:constr type="ctrY" for="ch" forName="visible" refType="h" fact="0.5"/>
            </dgm:constrLst>
            <dgm:ruleLst/>
            <dgm:layoutNode name="connSite">
              <dgm:alg type="sp"/>
              <dgm:shape xmlns:r="http://schemas.openxmlformats.org/officeDocument/2006/relationships" type="ellipse" r:blip="" hideGeom="1">
                <dgm:adjLst/>
              </dgm:shape>
              <dgm:presOf/>
              <dgm:constrLst/>
              <dgm:ruleLst/>
            </dgm:layoutNode>
            <dgm:layoutNode name="visible">
              <dgm:alg type="sp"/>
              <dgm:shape xmlns:r="http://schemas.openxmlformats.org/officeDocument/2006/relationships" type="ellipse" r:blip="" blipPhldr="1">
                <dgm:adjLst/>
              </dgm:shape>
              <dgm:presOf/>
              <dgm:constrLst/>
              <dgm:ruleLst/>
            </dgm:layoutNode>
          </dgm:layoutNode>
        </dgm:if>
        <dgm:else name="Name15"/>
      </dgm:choose>
      <dgm:forEach name="Name16" axis="ch">
        <dgm:forEach name="Name17" axis="self" ptType="node">
          <dgm:layoutNode name="node">
            <dgm:alg type="composite"/>
            <dgm:shape xmlns:r="http://schemas.openxmlformats.org/officeDocument/2006/relationships" r:blip="">
              <dgm:adjLst/>
            </dgm:shape>
            <dgm:presOf/>
            <dgm:choose name="Name18">
              <dgm:if name="Name19" func="var" arg="dir" op="equ" val="norm">
                <dgm:constrLst>
                  <dgm:constr type="t" for="ch" forName="parentNode"/>
                  <dgm:constr type="l" for="ch" forName="parentNode"/>
                  <dgm:constr type="w" for="ch" forName="parentNode" refType="w" fact="0.4"/>
                  <dgm:constr type="h" for="ch" forName="parentNode" refType="w" refFor="ch" refForName="parentNode" op="equ"/>
                  <dgm:constr type="ctrY" for="ch" forName="childNode" refType="h" refFor="ch" refForName="parentNode" fact="0.5"/>
                  <dgm:constr type="l" for="ch" forName="childNode" refType="w" refFor="ch" refForName="parentNode" op="equ" fact="1.1"/>
                  <dgm:constr type="w" for="ch" forName="childNode" refType="w" fact="0.6"/>
                  <dgm:constr type="h" for="ch" forName="childNode" refType="h" refFor="ch" refForName="parentNode"/>
                </dgm:constrLst>
              </dgm:if>
              <dgm:else name="Name20">
                <dgm:constrLst>
                  <dgm:constr type="t" for="ch" forName="parentNode"/>
                  <dgm:constr type="r" for="ch" forName="parentNode" refType="w"/>
                  <dgm:constr type="w" for="ch" forName="parentNode" refType="w" fact="0.4"/>
                  <dgm:constr type="h" for="ch" forName="parentNode" refType="w" refFor="ch" refForName="parentNode" op="equ"/>
                  <dgm:constr type="ctrY" for="ch" forName="childNode" refType="h" refFor="ch" refForName="parentNode" fact="0.5"/>
                  <dgm:constr type="l" for="ch" forName="childNode"/>
                  <dgm:constr type="w" for="ch" forName="childNode" refType="w" fact="0.6"/>
                  <dgm:constr type="h" for="ch" forName="childNode" refType="h" refFor="ch" refForName="parentNode"/>
                </dgm:constrLst>
              </dgm:else>
            </dgm:choose>
            <dgm:ruleLst/>
            <dgm:layoutNode name="parentNode" styleLbl="node1">
              <dgm:varLst>
                <dgm:chMax val="1"/>
                <dgm:bulletEnabled val="1"/>
              </dgm:varLst>
              <dgm:alg type="tx"/>
              <dgm:shape xmlns:r="http://schemas.openxmlformats.org/officeDocument/2006/relationships" type="ellipse" r:blip="">
                <dgm:adjLst/>
              </dgm:shape>
              <dgm:presOf axis="self"/>
              <dgm:constrLst>
                <dgm:constr type="tMarg" refType="primFontSz" fact="0.05"/>
                <dgm:constr type="bMarg" refType="primFontSz" fact="0.05"/>
                <dgm:constr type="lMarg" refType="primFontSz" fact="0.05"/>
                <dgm:constr type="rMarg" refType="primFontSz" fact="0.05"/>
              </dgm:constrLst>
              <dgm:ruleLst>
                <dgm:rule type="primFontSz" val="5" fact="NaN" max="NaN"/>
              </dgm:ruleLst>
            </dgm:layoutNode>
            <dgm:layoutNode name="childNode" styleLbl="revTx" moveWith="parentNode">
              <dgm:varLst>
                <dgm:bulletEnabled val="1"/>
              </dgm:varLst>
              <dgm:alg type="tx">
                <dgm:param type="txAnchorVertCh" val="mid"/>
                <dgm:param type="stBulletLvl" val="1"/>
              </dgm:alg>
              <dgm:choose name="Name21">
                <dgm:if name="Name22" axis="ch" ptType="node" func="cnt" op="gte" val="1">
                  <dgm:shape xmlns:r="http://schemas.openxmlformats.org/officeDocument/2006/relationships" type="rect" r:blip="">
                    <dgm:adjLst/>
                  </dgm:shape>
                </dgm:if>
                <dgm:else name="Name23">
                  <dgm:shape xmlns:r="http://schemas.openxmlformats.org/officeDocument/2006/relationships" type="rect" r:blip="" hideGeom="1">
                    <dgm:adjLst/>
                  </dgm:shape>
                </dgm:else>
              </dgm:choose>
              <dgm:presOf axis="des" ptType="node"/>
              <dgm:constrLst>
                <dgm:constr type="tMarg"/>
                <dgm:constr type="bMarg"/>
                <dgm:constr type="lMarg"/>
                <dgm:constr type="rMarg"/>
              </dgm:constrLst>
              <dgm:ruleLst>
                <dgm:rule type="secFontSz" val="5" fact="NaN" max="NaN"/>
              </dgm:ruleLst>
            </dgm:layoutNode>
          </dgm:layoutNode>
        </dgm:forEach>
        <dgm:forEach name="Name24" axis="self" ptType="parTrans" cnt="1">
          <dgm:layoutNode name="Name25">
            <dgm:alg type="conn">
              <dgm:param type="dim" val="1D"/>
              <dgm:param type="endSty" val="noArr"/>
              <dgm:param type="begPts" val="auto"/>
              <dgm:param type="endPts" val="auto"/>
              <dgm:param type="srcNode" val="connSite"/>
              <dgm:param type="dstNode" val="parentNode"/>
            </dgm:alg>
            <dgm:shape xmlns:r="http://schemas.openxmlformats.org/officeDocument/2006/relationships" type="conn" r:blip="" zOrderOff="-99">
              <dgm:adjLst/>
            </dgm:shape>
            <dgm:presOf axis="self"/>
            <dgm:constrLst>
              <dgm:constr type="connDist"/>
              <dgm:constr type="w" val="1"/>
              <dgm:constr type="h" val="5"/>
              <dgm:constr type="begPad"/>
              <dgm:constr type="endPad"/>
            </dgm:constrLst>
            <dgm:ruleLst/>
          </dgm:layoutNode>
        </dgm:forEach>
      </dgm:forEach>
    </dgm:layoutNod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92BD3-3DD2-4EEF-81DB-E07B7C96A3F2}" type="datetimeFigureOut">
              <a:rPr lang="en-GB" smtClean="0"/>
              <a:t>1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93C9-00EE-4451-8227-7E1255F35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9020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92BD3-3DD2-4EEF-81DB-E07B7C96A3F2}" type="datetimeFigureOut">
              <a:rPr lang="en-GB" smtClean="0"/>
              <a:t>1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93C9-00EE-4451-8227-7E1255F35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9460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92BD3-3DD2-4EEF-81DB-E07B7C96A3F2}" type="datetimeFigureOut">
              <a:rPr lang="en-GB" smtClean="0"/>
              <a:t>1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93C9-00EE-4451-8227-7E1255F35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5351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92BD3-3DD2-4EEF-81DB-E07B7C96A3F2}" type="datetimeFigureOut">
              <a:rPr lang="en-GB" smtClean="0"/>
              <a:t>1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93C9-00EE-4451-8227-7E1255F35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5255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92BD3-3DD2-4EEF-81DB-E07B7C96A3F2}" type="datetimeFigureOut">
              <a:rPr lang="en-GB" smtClean="0"/>
              <a:t>1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93C9-00EE-4451-8227-7E1255F35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6574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92BD3-3DD2-4EEF-81DB-E07B7C96A3F2}" type="datetimeFigureOut">
              <a:rPr lang="en-GB" smtClean="0"/>
              <a:t>14/02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93C9-00EE-4451-8227-7E1255F35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5572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92BD3-3DD2-4EEF-81DB-E07B7C96A3F2}" type="datetimeFigureOut">
              <a:rPr lang="en-GB" smtClean="0"/>
              <a:t>14/02/2020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93C9-00EE-4451-8227-7E1255F35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2906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92BD3-3DD2-4EEF-81DB-E07B7C96A3F2}" type="datetimeFigureOut">
              <a:rPr lang="en-GB" smtClean="0"/>
              <a:t>14/02/2020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93C9-00EE-4451-8227-7E1255F35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2444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92BD3-3DD2-4EEF-81DB-E07B7C96A3F2}" type="datetimeFigureOut">
              <a:rPr lang="en-GB" smtClean="0"/>
              <a:t>14/02/2020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93C9-00EE-4451-8227-7E1255F35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16652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92BD3-3DD2-4EEF-81DB-E07B7C96A3F2}" type="datetimeFigureOut">
              <a:rPr lang="en-GB" smtClean="0"/>
              <a:t>14/02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93C9-00EE-4451-8227-7E1255F35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1910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92BD3-3DD2-4EEF-81DB-E07B7C96A3F2}" type="datetimeFigureOut">
              <a:rPr lang="en-GB" smtClean="0"/>
              <a:t>14/02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393C9-00EE-4451-8227-7E1255F35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92554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292BD3-3DD2-4EEF-81DB-E07B7C96A3F2}" type="datetimeFigureOut">
              <a:rPr lang="en-GB" smtClean="0"/>
              <a:t>1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3393C9-00EE-4451-8227-7E1255F35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8268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diagramColors" Target="../diagrams/colors1.xml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openxmlformats.org/officeDocument/2006/relationships/diagramQuickStyle" Target="../diagrams/quickStyle1.xml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diagramLayout" Target="../diagrams/layout1.xml"/><Relationship Id="rId5" Type="http://schemas.openxmlformats.org/officeDocument/2006/relationships/image" Target="../media/image3.png"/><Relationship Id="rId10" Type="http://schemas.openxmlformats.org/officeDocument/2006/relationships/diagramData" Target="../diagrams/data1.xml"/><Relationship Id="rId4" Type="http://schemas.microsoft.com/office/2007/relationships/hdphoto" Target="../media/hdphoto1.wdp"/><Relationship Id="rId9" Type="http://schemas.openxmlformats.org/officeDocument/2006/relationships/image" Target="../media/image5.jpeg"/><Relationship Id="rId14" Type="http://schemas.microsoft.com/office/2007/relationships/diagramDrawing" Target="../diagrams/drawing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1.emf"/><Relationship Id="rId5" Type="http://schemas.openxmlformats.org/officeDocument/2006/relationships/image" Target="../media/image19.emf"/><Relationship Id="rId4" Type="http://schemas.openxmlformats.org/officeDocument/2006/relationships/package" Target="../embeddings/Microsoft_Word-Dokument1.docx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1" name="Gruppieren 110"/>
          <p:cNvGrpSpPr/>
          <p:nvPr/>
        </p:nvGrpSpPr>
        <p:grpSpPr>
          <a:xfrm>
            <a:off x="271054" y="150114"/>
            <a:ext cx="4932040" cy="3672407"/>
            <a:chOff x="278369" y="567069"/>
            <a:chExt cx="4932040" cy="3672407"/>
          </a:xfrm>
        </p:grpSpPr>
        <p:pic>
          <p:nvPicPr>
            <p:cNvPr id="21" name="Picture 2" descr="http://www.dermatology.ucsf.edu/skincancer/images/punchbiopsy.gif"/>
            <p:cNvPicPr>
              <a:picLocks noChangeAspect="1" noChangeArrowheads="1"/>
            </p:cNvPicPr>
            <p:nvPr/>
          </p:nvPicPr>
          <p:blipFill>
            <a:blip r:embed="rId2" cstate="print"/>
            <a:srcRect l="37177" t="-5966" b="-1419"/>
            <a:stretch>
              <a:fillRect/>
            </a:stretch>
          </p:blipFill>
          <p:spPr bwMode="auto">
            <a:xfrm>
              <a:off x="1249969" y="2420306"/>
              <a:ext cx="1708508" cy="1819170"/>
            </a:xfrm>
            <a:prstGeom prst="rect">
              <a:avLst/>
            </a:prstGeom>
            <a:noFill/>
          </p:spPr>
        </p:pic>
        <p:sp>
          <p:nvSpPr>
            <p:cNvPr id="22" name="Rechteck 21"/>
            <p:cNvSpPr/>
            <p:nvPr/>
          </p:nvSpPr>
          <p:spPr>
            <a:xfrm>
              <a:off x="2017221" y="2577946"/>
              <a:ext cx="102191" cy="76022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de-DE" dirty="0"/>
            </a:p>
          </p:txBody>
        </p:sp>
        <p:cxnSp>
          <p:nvCxnSpPr>
            <p:cNvPr id="23" name="Gerade Verbindung 18"/>
            <p:cNvCxnSpPr>
              <a:stCxn id="27" idx="1"/>
              <a:endCxn id="19" idx="2"/>
            </p:cNvCxnSpPr>
            <p:nvPr/>
          </p:nvCxnSpPr>
          <p:spPr>
            <a:xfrm flipH="1" flipV="1">
              <a:off x="1067276" y="2025019"/>
              <a:ext cx="649069" cy="5555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Gerade Verbindung 19"/>
            <p:cNvCxnSpPr>
              <a:endCxn id="14" idx="2"/>
            </p:cNvCxnSpPr>
            <p:nvPr/>
          </p:nvCxnSpPr>
          <p:spPr>
            <a:xfrm flipV="1">
              <a:off x="1904977" y="1736987"/>
              <a:ext cx="853979" cy="86051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Gerade Verbindung 20"/>
            <p:cNvCxnSpPr>
              <a:stCxn id="11" idx="2"/>
              <a:endCxn id="22" idx="3"/>
            </p:cNvCxnSpPr>
            <p:nvPr/>
          </p:nvCxnSpPr>
          <p:spPr>
            <a:xfrm flipH="1">
              <a:off x="2119412" y="2025019"/>
              <a:ext cx="2299286" cy="59093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Rechteck 25"/>
            <p:cNvSpPr/>
            <p:nvPr/>
          </p:nvSpPr>
          <p:spPr>
            <a:xfrm>
              <a:off x="1855018" y="2593988"/>
              <a:ext cx="100800" cy="7560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de-DE" dirty="0"/>
            </a:p>
          </p:txBody>
        </p:sp>
        <p:sp>
          <p:nvSpPr>
            <p:cNvPr id="27" name="Rechteck 26"/>
            <p:cNvSpPr/>
            <p:nvPr/>
          </p:nvSpPr>
          <p:spPr>
            <a:xfrm>
              <a:off x="1716345" y="2542759"/>
              <a:ext cx="100800" cy="7560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de-DE" dirty="0"/>
            </a:p>
          </p:txBody>
        </p:sp>
        <p:cxnSp>
          <p:nvCxnSpPr>
            <p:cNvPr id="6" name="Gerade Verbindung 36"/>
            <p:cNvCxnSpPr/>
            <p:nvPr/>
          </p:nvCxnSpPr>
          <p:spPr>
            <a:xfrm>
              <a:off x="2066441" y="2982506"/>
              <a:ext cx="360040" cy="0"/>
            </a:xfrm>
            <a:prstGeom prst="line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feld 6"/>
            <p:cNvSpPr txBox="1"/>
            <p:nvPr/>
          </p:nvSpPr>
          <p:spPr>
            <a:xfrm>
              <a:off x="2038876" y="2799317"/>
              <a:ext cx="7200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solidFill>
                    <a:schemeClr val="tx2"/>
                  </a:solidFill>
                  <a:latin typeface="Arial" pitchFamily="34" charset="0"/>
                  <a:cs typeface="Arial" pitchFamily="34" charset="0"/>
                </a:rPr>
                <a:t>4 mm</a:t>
              </a:r>
              <a:endParaRPr lang="de-DE" sz="800" b="1" dirty="0">
                <a:solidFill>
                  <a:schemeClr val="tx2"/>
                </a:solidFill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7" name="Gruppieren 16"/>
            <p:cNvGrpSpPr/>
            <p:nvPr/>
          </p:nvGrpSpPr>
          <p:grpSpPr>
            <a:xfrm>
              <a:off x="278369" y="855101"/>
              <a:ext cx="1577813" cy="1169918"/>
              <a:chOff x="-1980728" y="2204864"/>
              <a:chExt cx="1577813" cy="1169918"/>
            </a:xfrm>
          </p:grpSpPr>
          <p:pic>
            <p:nvPicPr>
              <p:cNvPr id="19" name="Picture 4" descr="C:\Users\HaPo\Dissertation\Fotos\Wundzungen\HS12-108\versch.färbungen\nm20%\HS12-108_nm20%_Ki67_d3_0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12000"/>
                        </a14:imgEffect>
                      </a14:imgLayer>
                    </a14:imgProps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980728" y="2204864"/>
                <a:ext cx="1577813" cy="1169918"/>
              </a:xfrm>
              <a:prstGeom prst="rect">
                <a:avLst/>
              </a:prstGeom>
              <a:noFill/>
            </p:spPr>
          </p:pic>
          <p:pic>
            <p:nvPicPr>
              <p:cNvPr id="20" name="Picture 4" descr="C:\Users\HaPo\Dissertation\Fotos\Wundzungen\HS12-108\versch.färbungen\nm20%\HS12-108_nm20%_Ki67_d3_0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12000"/>
                        </a14:imgEffect>
                      </a14:imgLayer>
                    </a14:imgProps>
                  </a:ext>
                </a:extLst>
              </a:blip>
              <a:srcRect l="86181" t="90213"/>
              <a:stretch>
                <a:fillRect/>
              </a:stretch>
            </p:blipFill>
            <p:spPr bwMode="auto">
              <a:xfrm>
                <a:off x="-628624" y="3211746"/>
                <a:ext cx="218045" cy="116264"/>
              </a:xfrm>
              <a:prstGeom prst="rect">
                <a:avLst/>
              </a:prstGeom>
              <a:noFill/>
            </p:spPr>
          </p:pic>
        </p:grpSp>
        <p:sp>
          <p:nvSpPr>
            <p:cNvPr id="18" name="Rechteck 17"/>
            <p:cNvSpPr/>
            <p:nvPr/>
          </p:nvSpPr>
          <p:spPr>
            <a:xfrm>
              <a:off x="278369" y="850418"/>
              <a:ext cx="1576649" cy="117460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de-DE"/>
            </a:p>
          </p:txBody>
        </p:sp>
        <p:pic>
          <p:nvPicPr>
            <p:cNvPr id="14" name="Picture 6" descr="C:\Users\HaPo\Dissertation\Fotos\HS12-108\Ki67\nm20%\HS12-108_nm20%_Ki67_d3_7.JP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12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70049" y="567069"/>
              <a:ext cx="1577813" cy="1169918"/>
            </a:xfrm>
            <a:prstGeom prst="rect">
              <a:avLst/>
            </a:prstGeom>
            <a:noFill/>
          </p:spPr>
        </p:pic>
        <p:sp>
          <p:nvSpPr>
            <p:cNvPr id="15" name="Rechteck 14"/>
            <p:cNvSpPr/>
            <p:nvPr/>
          </p:nvSpPr>
          <p:spPr>
            <a:xfrm>
              <a:off x="1970049" y="567069"/>
              <a:ext cx="1584176" cy="11699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de-DE"/>
            </a:p>
          </p:txBody>
        </p:sp>
        <p:pic>
          <p:nvPicPr>
            <p:cNvPr id="16" name="Picture 6" descr="C:\Users\HaPo\Dissertation\Fotos\HS12-108\Ki67\nm20%\HS12-108_nm20%_Ki67_d3_7.JP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12000"/>
                      </a14:imgEffect>
                    </a14:imgLayer>
                  </a14:imgProps>
                </a:ext>
              </a:extLst>
            </a:blip>
            <a:srcRect l="86181" t="90213"/>
            <a:stretch>
              <a:fillRect/>
            </a:stretch>
          </p:blipFill>
          <p:spPr bwMode="auto">
            <a:xfrm>
              <a:off x="3323121" y="1568065"/>
              <a:ext cx="218045" cy="116264"/>
            </a:xfrm>
            <a:prstGeom prst="rect">
              <a:avLst/>
            </a:prstGeom>
            <a:noFill/>
          </p:spPr>
        </p:pic>
        <p:pic>
          <p:nvPicPr>
            <p:cNvPr id="11" name="Picture 7" descr="C:\Users\HaPo\Dissertation\Fotos\Wundzungen\HS12-106\versch.Färbungen\nm20%\HS12-108_nm20%_Ki67_d3_9.JPG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12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29791" y="855101"/>
              <a:ext cx="1577813" cy="1169918"/>
            </a:xfrm>
            <a:prstGeom prst="rect">
              <a:avLst/>
            </a:prstGeom>
            <a:noFill/>
          </p:spPr>
        </p:pic>
        <p:pic>
          <p:nvPicPr>
            <p:cNvPr id="12" name="Picture 7" descr="C:\Users\HaPo\Dissertation\Fotos\Wundzungen\HS12-106\versch.Färbungen\nm20%\HS12-108_nm20%_Ki67_d3_9.JPG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12000"/>
                      </a14:imgEffect>
                    </a14:imgLayer>
                  </a14:imgProps>
                </a:ext>
              </a:extLst>
            </a:blip>
            <a:srcRect l="86181" t="90213"/>
            <a:stretch>
              <a:fillRect/>
            </a:stretch>
          </p:blipFill>
          <p:spPr bwMode="auto">
            <a:xfrm>
              <a:off x="4983711" y="1856097"/>
              <a:ext cx="218045" cy="116264"/>
            </a:xfrm>
            <a:prstGeom prst="rect">
              <a:avLst/>
            </a:prstGeom>
            <a:noFill/>
          </p:spPr>
        </p:pic>
        <p:sp>
          <p:nvSpPr>
            <p:cNvPr id="13" name="Rechteck 12"/>
            <p:cNvSpPr/>
            <p:nvPr/>
          </p:nvSpPr>
          <p:spPr>
            <a:xfrm>
              <a:off x="3626233" y="850307"/>
              <a:ext cx="1584176" cy="117471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de-DE"/>
            </a:p>
          </p:txBody>
        </p:sp>
      </p:grpSp>
      <p:pic>
        <p:nvPicPr>
          <p:cNvPr id="28" name="Picture 4" descr="C:\Users\HaPo\Dissertation\Fotos\handy\4-14B36632-669845-480.jp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911703" y="4045914"/>
            <a:ext cx="2073600" cy="1382400"/>
          </a:xfrm>
          <a:prstGeom prst="rect">
            <a:avLst/>
          </a:prstGeom>
          <a:noFill/>
        </p:spPr>
      </p:pic>
      <p:grpSp>
        <p:nvGrpSpPr>
          <p:cNvPr id="37" name="Gruppieren 36"/>
          <p:cNvGrpSpPr/>
          <p:nvPr/>
        </p:nvGrpSpPr>
        <p:grpSpPr>
          <a:xfrm>
            <a:off x="5178139" y="-84415"/>
            <a:ext cx="7854502" cy="4566834"/>
            <a:chOff x="1560512" y="546939"/>
            <a:chExt cx="9144000" cy="5616624"/>
          </a:xfrm>
        </p:grpSpPr>
        <p:graphicFrame>
          <p:nvGraphicFramePr>
            <p:cNvPr id="38" name="Inhaltsplatzhalter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82593813"/>
                </p:ext>
              </p:extLst>
            </p:nvPr>
          </p:nvGraphicFramePr>
          <p:xfrm>
            <a:off x="1560512" y="546939"/>
            <a:ext cx="9144000" cy="5616624"/>
          </p:xfrm>
          <a:graphic>
            <a:graphicData uri="http://schemas.openxmlformats.org/drawingml/2006/diagram">
              <dgm:relIds xmlns:dgm="http://schemas.openxmlformats.org/drawingml/2006/diagram" xmlns:r="http://schemas.openxmlformats.org/officeDocument/2006/relationships" r:dm="rId10" r:lo="rId11" r:qs="rId12" r:cs="rId13"/>
            </a:graphicData>
          </a:graphic>
        </p:graphicFrame>
        <p:sp>
          <p:nvSpPr>
            <p:cNvPr id="39" name="Textfeld 38"/>
            <p:cNvSpPr txBox="1"/>
            <p:nvPr/>
          </p:nvSpPr>
          <p:spPr>
            <a:xfrm>
              <a:off x="6903904" y="1031333"/>
              <a:ext cx="3168352" cy="3028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85750" indent="-285750">
                <a:buFont typeface="Wingdings" panose="05000000000000000000" pitchFamily="2" charset="2"/>
                <a:buChar char="Ø"/>
              </a:pPr>
              <a:r>
                <a:rPr lang="en-GB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8.8 </a:t>
              </a:r>
              <a:r>
                <a:rPr lang="en-GB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M (2500 mg/dl</a:t>
              </a:r>
              <a:r>
                <a:rPr lang="en-GB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feld 39"/>
            <p:cNvSpPr txBox="1"/>
            <p:nvPr/>
          </p:nvSpPr>
          <p:spPr>
            <a:xfrm>
              <a:off x="7046420" y="2327847"/>
              <a:ext cx="3168352" cy="428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GB" sz="1000" baseline="-25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285750" indent="-285750">
                <a:buFont typeface="Wingdings" panose="05000000000000000000" pitchFamily="2" charset="2"/>
                <a:buChar char="Ø"/>
              </a:pPr>
              <a:r>
                <a:rPr lang="de-DE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% Oxygen</a:t>
              </a:r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7075494" y="3795585"/>
              <a:ext cx="3168352" cy="3312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85750" indent="-285750">
                <a:buFont typeface="Wingdings" panose="05000000000000000000" pitchFamily="2" charset="2"/>
                <a:buChar char="Ø"/>
              </a:pPr>
              <a:r>
                <a:rPr lang="de-DE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ithdrawal</a:t>
              </a:r>
              <a:r>
                <a:rPr lang="de-DE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sulin</a:t>
              </a:r>
              <a:endParaRPr lang="en-GB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6550471" y="4853221"/>
              <a:ext cx="1368153" cy="3028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85750" indent="-285750">
                <a:buFont typeface="Wingdings" panose="05000000000000000000" pitchFamily="2" charset="2"/>
                <a:buChar char="Ø"/>
              </a:pPr>
              <a:r>
                <a:rPr lang="de-DE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 mM</a:t>
              </a:r>
              <a:endParaRPr lang="en-GB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feld 42"/>
            <p:cNvSpPr txBox="1"/>
            <p:nvPr/>
          </p:nvSpPr>
          <p:spPr>
            <a:xfrm>
              <a:off x="4075258" y="2971864"/>
              <a:ext cx="1026074" cy="5383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illiam‘s</a:t>
              </a:r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E.</a:t>
              </a:r>
            </a:p>
            <a:p>
              <a:pPr algn="ctr"/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dium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2" name="Gruppieren 111"/>
          <p:cNvGrpSpPr/>
          <p:nvPr/>
        </p:nvGrpSpPr>
        <p:grpSpPr>
          <a:xfrm>
            <a:off x="6961064" y="5000252"/>
            <a:ext cx="4950495" cy="1376588"/>
            <a:chOff x="4159913" y="4941168"/>
            <a:chExt cx="4950495" cy="1376588"/>
          </a:xfrm>
        </p:grpSpPr>
        <p:cxnSp>
          <p:nvCxnSpPr>
            <p:cNvPr id="113" name="Gerade Verbindung 39"/>
            <p:cNvCxnSpPr/>
            <p:nvPr/>
          </p:nvCxnSpPr>
          <p:spPr>
            <a:xfrm flipV="1">
              <a:off x="4549068" y="5707715"/>
              <a:ext cx="3927321" cy="391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Gerade Verbindung 41"/>
            <p:cNvCxnSpPr/>
            <p:nvPr/>
          </p:nvCxnSpPr>
          <p:spPr>
            <a:xfrm flipV="1">
              <a:off x="8476389" y="5707715"/>
              <a:ext cx="0" cy="34843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Gerade Verbindung 42"/>
            <p:cNvCxnSpPr/>
            <p:nvPr/>
          </p:nvCxnSpPr>
          <p:spPr>
            <a:xfrm flipV="1">
              <a:off x="7077061" y="5363195"/>
              <a:ext cx="0" cy="34843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Textfeld 115"/>
            <p:cNvSpPr txBox="1"/>
            <p:nvPr/>
          </p:nvSpPr>
          <p:spPr>
            <a:xfrm>
              <a:off x="8179642" y="6056146"/>
              <a:ext cx="57566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itchFamily="34" charset="0"/>
                  <a:cs typeface="Arial" pitchFamily="34" charset="0"/>
                </a:rPr>
                <a:t>Day 3</a:t>
              </a:r>
              <a:endParaRPr lang="de-DE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Textfeld 116"/>
            <p:cNvSpPr txBox="1"/>
            <p:nvPr/>
          </p:nvSpPr>
          <p:spPr>
            <a:xfrm>
              <a:off x="6783454" y="4946030"/>
              <a:ext cx="57566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itchFamily="34" charset="0"/>
                  <a:cs typeface="Arial" pitchFamily="34" charset="0"/>
                </a:rPr>
                <a:t>Day 2</a:t>
              </a:r>
              <a:endParaRPr lang="de-DE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Textfeld 117"/>
            <p:cNvSpPr txBox="1"/>
            <p:nvPr/>
          </p:nvSpPr>
          <p:spPr>
            <a:xfrm>
              <a:off x="8203938" y="5185317"/>
              <a:ext cx="9064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END </a:t>
              </a:r>
              <a:endParaRPr lang="de-DE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9" name="Gerade Verbindung 62"/>
            <p:cNvCxnSpPr/>
            <p:nvPr/>
          </p:nvCxnSpPr>
          <p:spPr>
            <a:xfrm flipV="1">
              <a:off x="7973695" y="5568343"/>
              <a:ext cx="0" cy="139372"/>
            </a:xfrm>
            <a:prstGeom prst="line">
              <a:avLst/>
            </a:prstGeom>
            <a:ln w="63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Gerade Verbindung 63"/>
            <p:cNvCxnSpPr/>
            <p:nvPr/>
          </p:nvCxnSpPr>
          <p:spPr>
            <a:xfrm flipV="1">
              <a:off x="7560189" y="5568343"/>
              <a:ext cx="0" cy="139372"/>
            </a:xfrm>
            <a:prstGeom prst="line">
              <a:avLst/>
            </a:prstGeom>
            <a:ln w="63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Gerade Verbindung 64"/>
            <p:cNvCxnSpPr/>
            <p:nvPr/>
          </p:nvCxnSpPr>
          <p:spPr>
            <a:xfrm flipV="1">
              <a:off x="6165621" y="5568343"/>
              <a:ext cx="0" cy="139372"/>
            </a:xfrm>
            <a:prstGeom prst="line">
              <a:avLst/>
            </a:prstGeom>
            <a:ln w="63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Gerade Verbindung 65"/>
            <p:cNvCxnSpPr/>
            <p:nvPr/>
          </p:nvCxnSpPr>
          <p:spPr>
            <a:xfrm flipV="1">
              <a:off x="6593721" y="5568343"/>
              <a:ext cx="0" cy="139372"/>
            </a:xfrm>
            <a:prstGeom prst="line">
              <a:avLst/>
            </a:prstGeom>
            <a:ln w="63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Rechteck 122"/>
            <p:cNvSpPr/>
            <p:nvPr/>
          </p:nvSpPr>
          <p:spPr>
            <a:xfrm>
              <a:off x="6105623" y="5091075"/>
              <a:ext cx="5309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H</a:t>
              </a:r>
              <a:r>
                <a:rPr lang="en-GB" sz="1200" baseline="-25000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2</a:t>
              </a:r>
              <a:r>
                <a:rPr lang="en-GB" sz="1200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  <a:r>
                <a:rPr lang="en-GB" sz="1200" baseline="-25000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2</a:t>
              </a:r>
              <a:endParaRPr lang="de-DE" sz="1200" dirty="0">
                <a:solidFill>
                  <a:schemeClr val="tx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Rechteck 123"/>
            <p:cNvSpPr/>
            <p:nvPr/>
          </p:nvSpPr>
          <p:spPr>
            <a:xfrm>
              <a:off x="7484724" y="5091075"/>
              <a:ext cx="5309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H</a:t>
              </a:r>
              <a:r>
                <a:rPr lang="en-GB" sz="1200" baseline="-25000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2</a:t>
              </a:r>
              <a:r>
                <a:rPr lang="en-GB" sz="1200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  <a:r>
                <a:rPr lang="en-GB" sz="1200" baseline="-25000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2</a:t>
              </a:r>
              <a:endParaRPr lang="de-DE" sz="1200" dirty="0">
                <a:solidFill>
                  <a:schemeClr val="tx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" name="Textfeld 124"/>
            <p:cNvSpPr txBox="1"/>
            <p:nvPr/>
          </p:nvSpPr>
          <p:spPr>
            <a:xfrm>
              <a:off x="6051072" y="5704024"/>
              <a:ext cx="57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>
                  <a:solidFill>
                    <a:schemeClr val="accent1"/>
                  </a:solidFill>
                  <a:latin typeface="Arial" pitchFamily="34" charset="0"/>
                  <a:cs typeface="Arial" pitchFamily="34" charset="0"/>
                </a:rPr>
                <a:t>6h</a:t>
              </a:r>
              <a:endParaRPr lang="de-DE" sz="1000" dirty="0">
                <a:solidFill>
                  <a:schemeClr val="accent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" name="Textfeld 125"/>
            <p:cNvSpPr txBox="1"/>
            <p:nvPr/>
          </p:nvSpPr>
          <p:spPr>
            <a:xfrm>
              <a:off x="6432500" y="5704024"/>
              <a:ext cx="57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>
                  <a:solidFill>
                    <a:schemeClr val="accent1"/>
                  </a:solidFill>
                  <a:latin typeface="Arial" pitchFamily="34" charset="0"/>
                  <a:cs typeface="Arial" pitchFamily="34" charset="0"/>
                </a:rPr>
                <a:t>12h</a:t>
              </a:r>
              <a:endParaRPr lang="de-DE" sz="1000" dirty="0">
                <a:solidFill>
                  <a:schemeClr val="accent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Textfeld 126"/>
            <p:cNvSpPr txBox="1"/>
            <p:nvPr/>
          </p:nvSpPr>
          <p:spPr>
            <a:xfrm>
              <a:off x="7435265" y="5704024"/>
              <a:ext cx="57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>
                  <a:solidFill>
                    <a:schemeClr val="accent1"/>
                  </a:solidFill>
                  <a:latin typeface="Arial" pitchFamily="34" charset="0"/>
                  <a:cs typeface="Arial" pitchFamily="34" charset="0"/>
                </a:rPr>
                <a:t>6h</a:t>
              </a:r>
              <a:endParaRPr lang="de-DE" sz="1000" dirty="0">
                <a:solidFill>
                  <a:schemeClr val="accent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" name="Textfeld 127"/>
            <p:cNvSpPr txBox="1"/>
            <p:nvPr/>
          </p:nvSpPr>
          <p:spPr>
            <a:xfrm>
              <a:off x="7798720" y="5704024"/>
              <a:ext cx="57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>
                  <a:solidFill>
                    <a:schemeClr val="accent1"/>
                  </a:solidFill>
                  <a:latin typeface="Arial" pitchFamily="34" charset="0"/>
                  <a:cs typeface="Arial" pitchFamily="34" charset="0"/>
                </a:rPr>
                <a:t>12h</a:t>
              </a:r>
              <a:endParaRPr lang="de-DE" sz="1000" dirty="0">
                <a:solidFill>
                  <a:schemeClr val="accent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9" name="Gerade Verbindung mit Pfeil 128"/>
            <p:cNvCxnSpPr/>
            <p:nvPr/>
          </p:nvCxnSpPr>
          <p:spPr>
            <a:xfrm flipV="1">
              <a:off x="8462336" y="5475558"/>
              <a:ext cx="0" cy="209058"/>
            </a:xfrm>
            <a:prstGeom prst="straightConnector1">
              <a:avLst/>
            </a:prstGeom>
            <a:ln w="19050">
              <a:headEnd type="arrow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Gerade Verbindung 40"/>
            <p:cNvCxnSpPr/>
            <p:nvPr/>
          </p:nvCxnSpPr>
          <p:spPr>
            <a:xfrm flipV="1">
              <a:off x="4549068" y="5361536"/>
              <a:ext cx="0" cy="34843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Gerade Verbindung 53"/>
            <p:cNvCxnSpPr/>
            <p:nvPr/>
          </p:nvCxnSpPr>
          <p:spPr>
            <a:xfrm flipV="1">
              <a:off x="5933129" y="5711428"/>
              <a:ext cx="0" cy="34843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Textfeld 131"/>
            <p:cNvSpPr txBox="1"/>
            <p:nvPr/>
          </p:nvSpPr>
          <p:spPr>
            <a:xfrm>
              <a:off x="4247456" y="4941168"/>
              <a:ext cx="57566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itchFamily="34" charset="0"/>
                  <a:cs typeface="Arial" pitchFamily="34" charset="0"/>
                </a:rPr>
                <a:t>Day 0</a:t>
              </a:r>
              <a:endParaRPr lang="de-DE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3" name="Textfeld 132"/>
            <p:cNvSpPr txBox="1"/>
            <p:nvPr/>
          </p:nvSpPr>
          <p:spPr>
            <a:xfrm>
              <a:off x="5642026" y="6056146"/>
              <a:ext cx="57566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>
                  <a:latin typeface="Arial" pitchFamily="34" charset="0"/>
                  <a:cs typeface="Arial" pitchFamily="34" charset="0"/>
                </a:rPr>
                <a:t>Day 1</a:t>
              </a:r>
              <a:endParaRPr lang="de-DE" sz="11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4" name="Gerade Verbindung mit Pfeil 133"/>
            <p:cNvCxnSpPr/>
            <p:nvPr/>
          </p:nvCxnSpPr>
          <p:spPr>
            <a:xfrm flipV="1">
              <a:off x="4555563" y="5753083"/>
              <a:ext cx="0" cy="209058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Textfeld 134"/>
            <p:cNvSpPr txBox="1"/>
            <p:nvPr/>
          </p:nvSpPr>
          <p:spPr>
            <a:xfrm>
              <a:off x="4159913" y="5977673"/>
              <a:ext cx="9064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START</a:t>
              </a:r>
              <a:endParaRPr lang="de-DE" sz="12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6" name="Gerade Verbindung 98"/>
            <p:cNvCxnSpPr/>
            <p:nvPr/>
          </p:nvCxnSpPr>
          <p:spPr>
            <a:xfrm flipV="1">
              <a:off x="5471592" y="5566959"/>
              <a:ext cx="0" cy="139372"/>
            </a:xfrm>
            <a:prstGeom prst="line">
              <a:avLst/>
            </a:prstGeom>
            <a:ln w="63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Gerade Verbindung 99"/>
            <p:cNvCxnSpPr/>
            <p:nvPr/>
          </p:nvCxnSpPr>
          <p:spPr>
            <a:xfrm flipV="1">
              <a:off x="5039544" y="5567149"/>
              <a:ext cx="0" cy="139372"/>
            </a:xfrm>
            <a:prstGeom prst="line">
              <a:avLst/>
            </a:prstGeom>
            <a:ln w="63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Textfeld 137"/>
            <p:cNvSpPr txBox="1"/>
            <p:nvPr/>
          </p:nvSpPr>
          <p:spPr>
            <a:xfrm>
              <a:off x="4914018" y="5704024"/>
              <a:ext cx="57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>
                  <a:solidFill>
                    <a:schemeClr val="accent1"/>
                  </a:solidFill>
                  <a:latin typeface="Arial" pitchFamily="34" charset="0"/>
                  <a:cs typeface="Arial" pitchFamily="34" charset="0"/>
                </a:rPr>
                <a:t>6h</a:t>
              </a:r>
              <a:endParaRPr lang="de-DE" sz="1000" dirty="0">
                <a:solidFill>
                  <a:schemeClr val="accent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9" name="Textfeld 138"/>
            <p:cNvSpPr txBox="1"/>
            <p:nvPr/>
          </p:nvSpPr>
          <p:spPr>
            <a:xfrm>
              <a:off x="5313346" y="5704024"/>
              <a:ext cx="57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>
                  <a:solidFill>
                    <a:schemeClr val="accent1"/>
                  </a:solidFill>
                  <a:latin typeface="Arial" pitchFamily="34" charset="0"/>
                  <a:cs typeface="Arial" pitchFamily="34" charset="0"/>
                </a:rPr>
                <a:t>12h</a:t>
              </a:r>
              <a:endParaRPr lang="de-DE" sz="1000" dirty="0">
                <a:solidFill>
                  <a:schemeClr val="accent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Rechteck 139"/>
            <p:cNvSpPr/>
            <p:nvPr/>
          </p:nvSpPr>
          <p:spPr>
            <a:xfrm>
              <a:off x="4967536" y="5091075"/>
              <a:ext cx="5309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H</a:t>
              </a:r>
              <a:r>
                <a:rPr lang="en-GB" sz="1200" baseline="-25000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2</a:t>
              </a:r>
              <a:r>
                <a:rPr lang="en-GB" sz="1200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O</a:t>
              </a:r>
              <a:r>
                <a:rPr lang="en-GB" sz="1200" baseline="-25000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" pitchFamily="34" charset="0"/>
                  <a:cs typeface="Arial" pitchFamily="34" charset="0"/>
                </a:rPr>
                <a:t>2</a:t>
              </a:r>
              <a:endParaRPr lang="de-DE" sz="1200" dirty="0">
                <a:solidFill>
                  <a:schemeClr val="tx2">
                    <a:lumMod val="60000"/>
                    <a:lumOff val="4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41" name="Textfeld 140"/>
          <p:cNvSpPr txBox="1"/>
          <p:nvPr/>
        </p:nvSpPr>
        <p:spPr>
          <a:xfrm>
            <a:off x="6776445" y="309442"/>
            <a:ext cx="12520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feld 141"/>
          <p:cNvSpPr txBox="1"/>
          <p:nvPr/>
        </p:nvSpPr>
        <p:spPr>
          <a:xfrm>
            <a:off x="6785388" y="4602571"/>
            <a:ext cx="12520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feld 142"/>
          <p:cNvSpPr txBox="1"/>
          <p:nvPr/>
        </p:nvSpPr>
        <p:spPr>
          <a:xfrm>
            <a:off x="-9363" y="278664"/>
            <a:ext cx="12520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-36662" y="6519161"/>
            <a:ext cx="29878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>
                <a:latin typeface="Arial" pitchFamily="34" charset="0"/>
                <a:cs typeface="Arial" pitchFamily="34" charset="0"/>
              </a:rPr>
              <a:t>Supplementary</a:t>
            </a:r>
            <a:r>
              <a:rPr lang="de-DE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600" b="1" dirty="0" err="1">
                <a:latin typeface="Arial" pitchFamily="34" charset="0"/>
                <a:cs typeface="Arial" pitchFamily="34" charset="0"/>
              </a:rPr>
              <a:t>figure</a:t>
            </a:r>
            <a:r>
              <a:rPr lang="de-DE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600" b="1" dirty="0" smtClean="0">
                <a:latin typeface="Arial" pitchFamily="34" charset="0"/>
                <a:cs typeface="Arial" pitchFamily="34" charset="0"/>
              </a:rPr>
              <a:t>1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64020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593837" y="147234"/>
            <a:ext cx="6011304" cy="6167218"/>
            <a:chOff x="695400" y="332656"/>
            <a:chExt cx="6011304" cy="6167218"/>
          </a:xfrm>
        </p:grpSpPr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911424" y="3861328"/>
              <a:ext cx="2062633" cy="252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4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215680" y="3861048"/>
              <a:ext cx="2330526" cy="252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7" name="Gruppieren 6"/>
            <p:cNvGrpSpPr/>
            <p:nvPr/>
          </p:nvGrpSpPr>
          <p:grpSpPr>
            <a:xfrm>
              <a:off x="695400" y="332656"/>
              <a:ext cx="6011304" cy="6167218"/>
              <a:chOff x="695400" y="332656"/>
              <a:chExt cx="6011304" cy="6167218"/>
            </a:xfrm>
          </p:grpSpPr>
          <p:grpSp>
            <p:nvGrpSpPr>
              <p:cNvPr id="8" name="Gruppieren 7"/>
              <p:cNvGrpSpPr/>
              <p:nvPr/>
            </p:nvGrpSpPr>
            <p:grpSpPr>
              <a:xfrm>
                <a:off x="980103" y="466006"/>
                <a:ext cx="2339321" cy="1622992"/>
                <a:chOff x="312303" y="15082"/>
                <a:chExt cx="2713504" cy="2043108"/>
              </a:xfrm>
            </p:grpSpPr>
            <p:pic>
              <p:nvPicPr>
                <p:cNvPr id="66" name="Grafik 65"/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12303" y="15082"/>
                  <a:ext cx="2713504" cy="2043108"/>
                </a:xfrm>
                <a:prstGeom prst="rect">
                  <a:avLst/>
                </a:prstGeom>
              </p:spPr>
            </p:pic>
            <p:pic>
              <p:nvPicPr>
                <p:cNvPr id="67" name="Grafik 66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3878" t="77818" r="2012" b="15989"/>
                <a:stretch/>
              </p:blipFill>
              <p:spPr>
                <a:xfrm>
                  <a:off x="2642960" y="1751082"/>
                  <a:ext cx="382846" cy="126560"/>
                </a:xfrm>
                <a:prstGeom prst="rect">
                  <a:avLst/>
                </a:prstGeom>
              </p:spPr>
            </p:pic>
          </p:grpSp>
          <p:sp>
            <p:nvSpPr>
              <p:cNvPr id="9" name="Textfeld 31"/>
              <p:cNvSpPr txBox="1"/>
              <p:nvPr/>
            </p:nvSpPr>
            <p:spPr>
              <a:xfrm>
                <a:off x="695400" y="1462600"/>
                <a:ext cx="357679" cy="660916"/>
              </a:xfrm>
              <a:prstGeom prst="rect">
                <a:avLst/>
              </a:prstGeom>
              <a:noFill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vert="vert270" wrap="square" rtlCol="0">
                <a:noAutofit/>
              </a:bodyPr>
              <a:lstStyle/>
              <a:p>
                <a:pPr>
                  <a:lnSpc>
                    <a:spcPct val="150000"/>
                  </a:lnSpc>
                  <a:spcAft>
                    <a:spcPts val="0"/>
                  </a:spcAft>
                </a:pPr>
                <a:r>
                  <a:rPr lang="de-DE" sz="1000" kern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Standard</a:t>
                </a:r>
                <a:endParaRPr lang="en-GB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0" name="Freihandform 9"/>
              <p:cNvSpPr/>
              <p:nvPr/>
            </p:nvSpPr>
            <p:spPr>
              <a:xfrm>
                <a:off x="1967883" y="649407"/>
                <a:ext cx="561240" cy="1294843"/>
              </a:xfrm>
              <a:custGeom>
                <a:avLst/>
                <a:gdLst>
                  <a:gd name="connsiteX0" fmla="*/ 0 w 651013"/>
                  <a:gd name="connsiteY0" fmla="*/ 198783 h 1630018"/>
                  <a:gd name="connsiteX1" fmla="*/ 124239 w 651013"/>
                  <a:gd name="connsiteY1" fmla="*/ 318053 h 1630018"/>
                  <a:gd name="connsiteX2" fmla="*/ 213691 w 651013"/>
                  <a:gd name="connsiteY2" fmla="*/ 337931 h 1630018"/>
                  <a:gd name="connsiteX3" fmla="*/ 318052 w 651013"/>
                  <a:gd name="connsiteY3" fmla="*/ 432353 h 1630018"/>
                  <a:gd name="connsiteX4" fmla="*/ 342900 w 651013"/>
                  <a:gd name="connsiteY4" fmla="*/ 516835 h 1630018"/>
                  <a:gd name="connsiteX5" fmla="*/ 332961 w 651013"/>
                  <a:gd name="connsiteY5" fmla="*/ 561561 h 1630018"/>
                  <a:gd name="connsiteX6" fmla="*/ 303143 w 651013"/>
                  <a:gd name="connsiteY6" fmla="*/ 660953 h 1630018"/>
                  <a:gd name="connsiteX7" fmla="*/ 318052 w 651013"/>
                  <a:gd name="connsiteY7" fmla="*/ 854766 h 1630018"/>
                  <a:gd name="connsiteX8" fmla="*/ 238539 w 651013"/>
                  <a:gd name="connsiteY8" fmla="*/ 993914 h 1630018"/>
                  <a:gd name="connsiteX9" fmla="*/ 337930 w 651013"/>
                  <a:gd name="connsiteY9" fmla="*/ 1232453 h 1630018"/>
                  <a:gd name="connsiteX10" fmla="*/ 487017 w 651013"/>
                  <a:gd name="connsiteY10" fmla="*/ 1470992 h 1630018"/>
                  <a:gd name="connsiteX11" fmla="*/ 576469 w 651013"/>
                  <a:gd name="connsiteY11" fmla="*/ 1630018 h 1630018"/>
                  <a:gd name="connsiteX12" fmla="*/ 606287 w 651013"/>
                  <a:gd name="connsiteY12" fmla="*/ 1341783 h 1630018"/>
                  <a:gd name="connsiteX13" fmla="*/ 551622 w 651013"/>
                  <a:gd name="connsiteY13" fmla="*/ 1118153 h 1630018"/>
                  <a:gd name="connsiteX14" fmla="*/ 651013 w 651013"/>
                  <a:gd name="connsiteY14" fmla="*/ 795131 h 1630018"/>
                  <a:gd name="connsiteX15" fmla="*/ 571500 w 651013"/>
                  <a:gd name="connsiteY15" fmla="*/ 462170 h 1630018"/>
                  <a:gd name="connsiteX16" fmla="*/ 422413 w 651013"/>
                  <a:gd name="connsiteY16" fmla="*/ 173935 h 1630018"/>
                  <a:gd name="connsiteX17" fmla="*/ 198783 w 651013"/>
                  <a:gd name="connsiteY17" fmla="*/ 0 h 1630018"/>
                  <a:gd name="connsiteX18" fmla="*/ 0 w 651013"/>
                  <a:gd name="connsiteY18" fmla="*/ 198783 h 16300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</a:cxnLst>
                <a:rect l="l" t="t" r="r" b="b"/>
                <a:pathLst>
                  <a:path w="651013" h="1630018">
                    <a:moveTo>
                      <a:pt x="0" y="198783"/>
                    </a:moveTo>
                    <a:lnTo>
                      <a:pt x="124239" y="318053"/>
                    </a:lnTo>
                    <a:lnTo>
                      <a:pt x="213691" y="337931"/>
                    </a:lnTo>
                    <a:lnTo>
                      <a:pt x="318052" y="432353"/>
                    </a:lnTo>
                    <a:lnTo>
                      <a:pt x="342900" y="516835"/>
                    </a:lnTo>
                    <a:lnTo>
                      <a:pt x="332961" y="561561"/>
                    </a:lnTo>
                    <a:lnTo>
                      <a:pt x="303143" y="660953"/>
                    </a:lnTo>
                    <a:lnTo>
                      <a:pt x="318052" y="854766"/>
                    </a:lnTo>
                    <a:lnTo>
                      <a:pt x="238539" y="993914"/>
                    </a:lnTo>
                    <a:lnTo>
                      <a:pt x="337930" y="1232453"/>
                    </a:lnTo>
                    <a:lnTo>
                      <a:pt x="487017" y="1470992"/>
                    </a:lnTo>
                    <a:lnTo>
                      <a:pt x="576469" y="1630018"/>
                    </a:lnTo>
                    <a:lnTo>
                      <a:pt x="606287" y="1341783"/>
                    </a:lnTo>
                    <a:lnTo>
                      <a:pt x="551622" y="1118153"/>
                    </a:lnTo>
                    <a:lnTo>
                      <a:pt x="651013" y="795131"/>
                    </a:lnTo>
                    <a:lnTo>
                      <a:pt x="571500" y="462170"/>
                    </a:lnTo>
                    <a:lnTo>
                      <a:pt x="422413" y="173935"/>
                    </a:lnTo>
                    <a:lnTo>
                      <a:pt x="198783" y="0"/>
                    </a:lnTo>
                    <a:lnTo>
                      <a:pt x="0" y="198783"/>
                    </a:lnTo>
                    <a:close/>
                  </a:path>
                </a:pathLst>
              </a:custGeom>
              <a:noFill/>
              <a:ln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en-GB"/>
              </a:p>
            </p:txBody>
          </p:sp>
          <p:sp>
            <p:nvSpPr>
              <p:cNvPr id="11" name="Freihandform 10"/>
              <p:cNvSpPr/>
              <p:nvPr/>
            </p:nvSpPr>
            <p:spPr>
              <a:xfrm>
                <a:off x="1946462" y="854689"/>
                <a:ext cx="496976" cy="1125092"/>
              </a:xfrm>
              <a:custGeom>
                <a:avLst/>
                <a:gdLst>
                  <a:gd name="connsiteX0" fmla="*/ 0 w 576469"/>
                  <a:gd name="connsiteY0" fmla="*/ 0 h 1416326"/>
                  <a:gd name="connsiteX1" fmla="*/ 139147 w 576469"/>
                  <a:gd name="connsiteY1" fmla="*/ 114300 h 1416326"/>
                  <a:gd name="connsiteX2" fmla="*/ 243508 w 576469"/>
                  <a:gd name="connsiteY2" fmla="*/ 144117 h 1416326"/>
                  <a:gd name="connsiteX3" fmla="*/ 323021 w 576469"/>
                  <a:gd name="connsiteY3" fmla="*/ 238539 h 1416326"/>
                  <a:gd name="connsiteX4" fmla="*/ 308113 w 576469"/>
                  <a:gd name="connsiteY4" fmla="*/ 342900 h 1416326"/>
                  <a:gd name="connsiteX5" fmla="*/ 288234 w 576469"/>
                  <a:gd name="connsiteY5" fmla="*/ 412474 h 1416326"/>
                  <a:gd name="connsiteX6" fmla="*/ 303143 w 576469"/>
                  <a:gd name="connsiteY6" fmla="*/ 581439 h 1416326"/>
                  <a:gd name="connsiteX7" fmla="*/ 223630 w 576469"/>
                  <a:gd name="connsiteY7" fmla="*/ 740465 h 1416326"/>
                  <a:gd name="connsiteX8" fmla="*/ 561561 w 576469"/>
                  <a:gd name="connsiteY8" fmla="*/ 1406387 h 1416326"/>
                  <a:gd name="connsiteX9" fmla="*/ 576469 w 576469"/>
                  <a:gd name="connsiteY9" fmla="*/ 1416326 h 141632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576469" h="1416326">
                    <a:moveTo>
                      <a:pt x="0" y="0"/>
                    </a:moveTo>
                    <a:lnTo>
                      <a:pt x="139147" y="114300"/>
                    </a:lnTo>
                    <a:lnTo>
                      <a:pt x="243508" y="144117"/>
                    </a:lnTo>
                    <a:lnTo>
                      <a:pt x="323021" y="238539"/>
                    </a:lnTo>
                    <a:lnTo>
                      <a:pt x="308113" y="342900"/>
                    </a:lnTo>
                    <a:lnTo>
                      <a:pt x="288234" y="412474"/>
                    </a:lnTo>
                    <a:lnTo>
                      <a:pt x="303143" y="581439"/>
                    </a:lnTo>
                    <a:lnTo>
                      <a:pt x="223630" y="740465"/>
                    </a:lnTo>
                    <a:lnTo>
                      <a:pt x="561561" y="1406387"/>
                    </a:lnTo>
                    <a:lnTo>
                      <a:pt x="576469" y="1416326"/>
                    </a:lnTo>
                  </a:path>
                </a:pathLst>
              </a:cu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en-GB"/>
              </a:p>
            </p:txBody>
          </p:sp>
          <p:grpSp>
            <p:nvGrpSpPr>
              <p:cNvPr id="12" name="Gruppieren 11"/>
              <p:cNvGrpSpPr/>
              <p:nvPr/>
            </p:nvGrpSpPr>
            <p:grpSpPr>
              <a:xfrm>
                <a:off x="3530346" y="457680"/>
                <a:ext cx="2341724" cy="1624753"/>
                <a:chOff x="309602" y="1990276"/>
                <a:chExt cx="2578780" cy="2034006"/>
              </a:xfrm>
            </p:grpSpPr>
            <p:pic>
              <p:nvPicPr>
                <p:cNvPr id="64" name="Grafik 63"/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09602" y="1990276"/>
                  <a:ext cx="2578780" cy="2034006"/>
                </a:xfrm>
                <a:prstGeom prst="rect">
                  <a:avLst/>
                </a:prstGeom>
              </p:spPr>
            </p:pic>
            <p:pic>
              <p:nvPicPr>
                <p:cNvPr id="65" name="Grafik 64"/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1026" t="76245" r="10459" b="15091"/>
                <a:stretch/>
              </p:blipFill>
              <p:spPr>
                <a:xfrm>
                  <a:off x="2578050" y="3743167"/>
                  <a:ext cx="301780" cy="95029"/>
                </a:xfrm>
                <a:prstGeom prst="rect">
                  <a:avLst/>
                </a:prstGeom>
              </p:spPr>
            </p:pic>
          </p:grpSp>
          <p:sp>
            <p:nvSpPr>
              <p:cNvPr id="13" name="Textfeld 33"/>
              <p:cNvSpPr txBox="1"/>
              <p:nvPr/>
            </p:nvSpPr>
            <p:spPr>
              <a:xfrm>
                <a:off x="3233200" y="1052736"/>
                <a:ext cx="357711" cy="1045720"/>
              </a:xfrm>
              <a:prstGeom prst="rect">
                <a:avLst/>
              </a:prstGeom>
              <a:noFill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vert="vert270" wrap="square" rtlCol="0">
                <a:noAutofit/>
              </a:bodyPr>
              <a:lstStyle/>
              <a:p>
                <a:pPr>
                  <a:lnSpc>
                    <a:spcPct val="150000"/>
                  </a:lnSpc>
                  <a:spcAft>
                    <a:spcPts val="0"/>
                  </a:spcAft>
                </a:pPr>
                <a:r>
                  <a:rPr lang="de-DE" sz="1000" kern="1200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„Pathological“</a:t>
                </a:r>
                <a:endParaRPr lang="en-GB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grpSp>
            <p:nvGrpSpPr>
              <p:cNvPr id="14" name="Gruppieren 13"/>
              <p:cNvGrpSpPr/>
              <p:nvPr/>
            </p:nvGrpSpPr>
            <p:grpSpPr>
              <a:xfrm>
                <a:off x="972883" y="2126913"/>
                <a:ext cx="2341257" cy="1624334"/>
                <a:chOff x="3156879" y="0"/>
                <a:chExt cx="2715750" cy="2044800"/>
              </a:xfrm>
            </p:grpSpPr>
            <p:pic>
              <p:nvPicPr>
                <p:cNvPr id="62" name="Grafik 61"/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156879" y="0"/>
                  <a:ext cx="2715750" cy="2044800"/>
                </a:xfrm>
                <a:prstGeom prst="rect">
                  <a:avLst/>
                </a:prstGeom>
              </p:spPr>
            </p:pic>
            <p:pic>
              <p:nvPicPr>
                <p:cNvPr id="63" name="Grafik 62"/>
                <p:cNvPicPr>
                  <a:picLocks noChangeAspect="1"/>
                </p:cNvPicPr>
                <p:nvPr/>
              </p:nvPicPr>
              <p:blipFill rotWithShape="1"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7764" t="70981" r="20408" b="14833"/>
                <a:stretch/>
              </p:blipFill>
              <p:spPr>
                <a:xfrm>
                  <a:off x="5268991" y="1641203"/>
                  <a:ext cx="592784" cy="290086"/>
                </a:xfrm>
                <a:prstGeom prst="rect">
                  <a:avLst/>
                </a:prstGeom>
              </p:spPr>
            </p:pic>
          </p:grpSp>
          <p:sp>
            <p:nvSpPr>
              <p:cNvPr id="15" name="Textfeld 35"/>
              <p:cNvSpPr txBox="1"/>
              <p:nvPr/>
            </p:nvSpPr>
            <p:spPr>
              <a:xfrm>
                <a:off x="697287" y="2885442"/>
                <a:ext cx="357679" cy="940109"/>
              </a:xfrm>
              <a:prstGeom prst="rect">
                <a:avLst/>
              </a:prstGeom>
              <a:noFill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vert="vert270" wrap="square" rtlCol="0">
                <a:noAutofit/>
              </a:bodyPr>
              <a:lstStyle/>
              <a:p>
                <a:pPr>
                  <a:lnSpc>
                    <a:spcPct val="150000"/>
                  </a:lnSpc>
                  <a:spcAft>
                    <a:spcPts val="0"/>
                  </a:spcAft>
                </a:pPr>
                <a:r>
                  <a:rPr lang="de-DE" sz="1000" kern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Standard + T4</a:t>
                </a:r>
                <a:endParaRPr lang="en-GB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6" name="Freihandform 15"/>
              <p:cNvSpPr/>
              <p:nvPr/>
            </p:nvSpPr>
            <p:spPr>
              <a:xfrm>
                <a:off x="1161440" y="2401288"/>
                <a:ext cx="1606604" cy="1358005"/>
              </a:xfrm>
              <a:custGeom>
                <a:avLst/>
                <a:gdLst>
                  <a:gd name="connsiteX0" fmla="*/ 1098274 w 1863587"/>
                  <a:gd name="connsiteY0" fmla="*/ 0 h 1709531"/>
                  <a:gd name="connsiteX1" fmla="*/ 964096 w 1863587"/>
                  <a:gd name="connsiteY1" fmla="*/ 168966 h 1709531"/>
                  <a:gd name="connsiteX2" fmla="*/ 864705 w 1863587"/>
                  <a:gd name="connsiteY2" fmla="*/ 159026 h 1709531"/>
                  <a:gd name="connsiteX3" fmla="*/ 760344 w 1863587"/>
                  <a:gd name="connsiteY3" fmla="*/ 243509 h 1709531"/>
                  <a:gd name="connsiteX4" fmla="*/ 844826 w 1863587"/>
                  <a:gd name="connsiteY4" fmla="*/ 491987 h 1709531"/>
                  <a:gd name="connsiteX5" fmla="*/ 705678 w 1863587"/>
                  <a:gd name="connsiteY5" fmla="*/ 730526 h 1709531"/>
                  <a:gd name="connsiteX6" fmla="*/ 725557 w 1863587"/>
                  <a:gd name="connsiteY6" fmla="*/ 919370 h 1709531"/>
                  <a:gd name="connsiteX7" fmla="*/ 531744 w 1863587"/>
                  <a:gd name="connsiteY7" fmla="*/ 1043609 h 1709531"/>
                  <a:gd name="connsiteX8" fmla="*/ 198783 w 1863587"/>
                  <a:gd name="connsiteY8" fmla="*/ 1157909 h 1709531"/>
                  <a:gd name="connsiteX9" fmla="*/ 0 w 1863587"/>
                  <a:gd name="connsiteY9" fmla="*/ 1565413 h 1709531"/>
                  <a:gd name="connsiteX10" fmla="*/ 9939 w 1863587"/>
                  <a:gd name="connsiteY10" fmla="*/ 1610139 h 1709531"/>
                  <a:gd name="connsiteX11" fmla="*/ 19878 w 1863587"/>
                  <a:gd name="connsiteY11" fmla="*/ 1620079 h 1709531"/>
                  <a:gd name="connsiteX12" fmla="*/ 29818 w 1863587"/>
                  <a:gd name="connsiteY12" fmla="*/ 1639957 h 1709531"/>
                  <a:gd name="connsiteX13" fmla="*/ 79513 w 1863587"/>
                  <a:gd name="connsiteY13" fmla="*/ 1694622 h 1709531"/>
                  <a:gd name="connsiteX14" fmla="*/ 84483 w 1863587"/>
                  <a:gd name="connsiteY14" fmla="*/ 1709531 h 1709531"/>
                  <a:gd name="connsiteX15" fmla="*/ 99392 w 1863587"/>
                  <a:gd name="connsiteY15" fmla="*/ 1669774 h 1709531"/>
                  <a:gd name="connsiteX16" fmla="*/ 104361 w 1863587"/>
                  <a:gd name="connsiteY16" fmla="*/ 1654866 h 1709531"/>
                  <a:gd name="connsiteX17" fmla="*/ 99392 w 1863587"/>
                  <a:gd name="connsiteY17" fmla="*/ 1659835 h 1709531"/>
                  <a:gd name="connsiteX18" fmla="*/ 327992 w 1863587"/>
                  <a:gd name="connsiteY18" fmla="*/ 1515718 h 1709531"/>
                  <a:gd name="connsiteX19" fmla="*/ 715618 w 1863587"/>
                  <a:gd name="connsiteY19" fmla="*/ 1371600 h 1709531"/>
                  <a:gd name="connsiteX20" fmla="*/ 810039 w 1863587"/>
                  <a:gd name="connsiteY20" fmla="*/ 1282148 h 1709531"/>
                  <a:gd name="connsiteX21" fmla="*/ 1128092 w 1863587"/>
                  <a:gd name="connsiteY21" fmla="*/ 1162879 h 1709531"/>
                  <a:gd name="connsiteX22" fmla="*/ 1306996 w 1863587"/>
                  <a:gd name="connsiteY22" fmla="*/ 934279 h 1709531"/>
                  <a:gd name="connsiteX23" fmla="*/ 1709531 w 1863587"/>
                  <a:gd name="connsiteY23" fmla="*/ 546653 h 1709531"/>
                  <a:gd name="connsiteX24" fmla="*/ 1863587 w 1863587"/>
                  <a:gd name="connsiteY24" fmla="*/ 198783 h 1709531"/>
                  <a:gd name="connsiteX25" fmla="*/ 1838739 w 1863587"/>
                  <a:gd name="connsiteY25" fmla="*/ 4970 h 1709531"/>
                  <a:gd name="connsiteX26" fmla="*/ 1098274 w 1863587"/>
                  <a:gd name="connsiteY26" fmla="*/ 0 h 17095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</a:cxnLst>
                <a:rect l="l" t="t" r="r" b="b"/>
                <a:pathLst>
                  <a:path w="1863587" h="1709531">
                    <a:moveTo>
                      <a:pt x="1098274" y="0"/>
                    </a:moveTo>
                    <a:lnTo>
                      <a:pt x="964096" y="168966"/>
                    </a:lnTo>
                    <a:lnTo>
                      <a:pt x="864705" y="159026"/>
                    </a:lnTo>
                    <a:lnTo>
                      <a:pt x="760344" y="243509"/>
                    </a:lnTo>
                    <a:lnTo>
                      <a:pt x="844826" y="491987"/>
                    </a:lnTo>
                    <a:lnTo>
                      <a:pt x="705678" y="730526"/>
                    </a:lnTo>
                    <a:lnTo>
                      <a:pt x="725557" y="919370"/>
                    </a:lnTo>
                    <a:lnTo>
                      <a:pt x="531744" y="1043609"/>
                    </a:lnTo>
                    <a:lnTo>
                      <a:pt x="198783" y="1157909"/>
                    </a:lnTo>
                    <a:lnTo>
                      <a:pt x="0" y="1565413"/>
                    </a:lnTo>
                    <a:cubicBezTo>
                      <a:pt x="3313" y="1580322"/>
                      <a:pt x="4720" y="1595786"/>
                      <a:pt x="9939" y="1610139"/>
                    </a:cubicBezTo>
                    <a:cubicBezTo>
                      <a:pt x="11540" y="1614542"/>
                      <a:pt x="17279" y="1616180"/>
                      <a:pt x="19878" y="1620079"/>
                    </a:cubicBezTo>
                    <a:cubicBezTo>
                      <a:pt x="23987" y="1626243"/>
                      <a:pt x="25075" y="1634266"/>
                      <a:pt x="29818" y="1639957"/>
                    </a:cubicBezTo>
                    <a:cubicBezTo>
                      <a:pt x="44917" y="1658076"/>
                      <a:pt x="68382" y="1672361"/>
                      <a:pt x="79513" y="1694622"/>
                    </a:cubicBezTo>
                    <a:cubicBezTo>
                      <a:pt x="81856" y="1699307"/>
                      <a:pt x="82826" y="1704561"/>
                      <a:pt x="84483" y="1709531"/>
                    </a:cubicBezTo>
                    <a:cubicBezTo>
                      <a:pt x="100844" y="1684989"/>
                      <a:pt x="90795" y="1704162"/>
                      <a:pt x="99392" y="1669774"/>
                    </a:cubicBezTo>
                    <a:cubicBezTo>
                      <a:pt x="100662" y="1664692"/>
                      <a:pt x="104361" y="1660104"/>
                      <a:pt x="104361" y="1654866"/>
                    </a:cubicBezTo>
                    <a:lnTo>
                      <a:pt x="99392" y="1659835"/>
                    </a:lnTo>
                    <a:lnTo>
                      <a:pt x="327992" y="1515718"/>
                    </a:lnTo>
                    <a:lnTo>
                      <a:pt x="715618" y="1371600"/>
                    </a:lnTo>
                    <a:lnTo>
                      <a:pt x="810039" y="1282148"/>
                    </a:lnTo>
                    <a:lnTo>
                      <a:pt x="1128092" y="1162879"/>
                    </a:lnTo>
                    <a:lnTo>
                      <a:pt x="1306996" y="934279"/>
                    </a:lnTo>
                    <a:lnTo>
                      <a:pt x="1709531" y="546653"/>
                    </a:lnTo>
                    <a:lnTo>
                      <a:pt x="1863587" y="198783"/>
                    </a:lnTo>
                    <a:lnTo>
                      <a:pt x="1838739" y="4970"/>
                    </a:lnTo>
                    <a:lnTo>
                      <a:pt x="1098274" y="0"/>
                    </a:lnTo>
                    <a:close/>
                  </a:path>
                </a:pathLst>
              </a:custGeom>
              <a:noFill/>
              <a:ln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en-GB"/>
              </a:p>
            </p:txBody>
          </p:sp>
          <p:sp>
            <p:nvSpPr>
              <p:cNvPr id="17" name="Freihandform 16"/>
              <p:cNvSpPr/>
              <p:nvPr/>
            </p:nvSpPr>
            <p:spPr>
              <a:xfrm>
                <a:off x="1132413" y="2368464"/>
                <a:ext cx="965781" cy="1214459"/>
              </a:xfrm>
              <a:custGeom>
                <a:avLst/>
                <a:gdLst>
                  <a:gd name="connsiteX0" fmla="*/ 1068457 w 1068457"/>
                  <a:gd name="connsiteY0" fmla="*/ 0 h 1490870"/>
                  <a:gd name="connsiteX1" fmla="*/ 964096 w 1068457"/>
                  <a:gd name="connsiteY1" fmla="*/ 129209 h 1490870"/>
                  <a:gd name="connsiteX2" fmla="*/ 864705 w 1068457"/>
                  <a:gd name="connsiteY2" fmla="*/ 104361 h 1490870"/>
                  <a:gd name="connsiteX3" fmla="*/ 750405 w 1068457"/>
                  <a:gd name="connsiteY3" fmla="*/ 198783 h 1490870"/>
                  <a:gd name="connsiteX4" fmla="*/ 725557 w 1068457"/>
                  <a:gd name="connsiteY4" fmla="*/ 228600 h 1490870"/>
                  <a:gd name="connsiteX5" fmla="*/ 790161 w 1068457"/>
                  <a:gd name="connsiteY5" fmla="*/ 501926 h 1490870"/>
                  <a:gd name="connsiteX6" fmla="*/ 660953 w 1068457"/>
                  <a:gd name="connsiteY6" fmla="*/ 655983 h 1490870"/>
                  <a:gd name="connsiteX7" fmla="*/ 680831 w 1068457"/>
                  <a:gd name="connsiteY7" fmla="*/ 874644 h 1490870"/>
                  <a:gd name="connsiteX8" fmla="*/ 223631 w 1068457"/>
                  <a:gd name="connsiteY8" fmla="*/ 1073426 h 1490870"/>
                  <a:gd name="connsiteX9" fmla="*/ 0 w 1068457"/>
                  <a:gd name="connsiteY9" fmla="*/ 1490870 h 1490870"/>
                  <a:gd name="connsiteX10" fmla="*/ 0 w 1068457"/>
                  <a:gd name="connsiteY10" fmla="*/ 1490870 h 1490870"/>
                  <a:gd name="connsiteX0" fmla="*/ 1068457 w 1068457"/>
                  <a:gd name="connsiteY0" fmla="*/ 0 h 1490870"/>
                  <a:gd name="connsiteX1" fmla="*/ 964096 w 1068457"/>
                  <a:gd name="connsiteY1" fmla="*/ 129209 h 1490870"/>
                  <a:gd name="connsiteX2" fmla="*/ 864705 w 1068457"/>
                  <a:gd name="connsiteY2" fmla="*/ 104361 h 1490870"/>
                  <a:gd name="connsiteX3" fmla="*/ 750405 w 1068457"/>
                  <a:gd name="connsiteY3" fmla="*/ 198783 h 1490870"/>
                  <a:gd name="connsiteX4" fmla="*/ 700725 w 1068457"/>
                  <a:gd name="connsiteY4" fmla="*/ 255011 h 1490870"/>
                  <a:gd name="connsiteX5" fmla="*/ 790161 w 1068457"/>
                  <a:gd name="connsiteY5" fmla="*/ 501926 h 1490870"/>
                  <a:gd name="connsiteX6" fmla="*/ 660953 w 1068457"/>
                  <a:gd name="connsiteY6" fmla="*/ 655983 h 1490870"/>
                  <a:gd name="connsiteX7" fmla="*/ 680831 w 1068457"/>
                  <a:gd name="connsiteY7" fmla="*/ 874644 h 1490870"/>
                  <a:gd name="connsiteX8" fmla="*/ 223631 w 1068457"/>
                  <a:gd name="connsiteY8" fmla="*/ 1073426 h 1490870"/>
                  <a:gd name="connsiteX9" fmla="*/ 0 w 1068457"/>
                  <a:gd name="connsiteY9" fmla="*/ 1490870 h 1490870"/>
                  <a:gd name="connsiteX10" fmla="*/ 0 w 1068457"/>
                  <a:gd name="connsiteY10" fmla="*/ 1490870 h 1490870"/>
                  <a:gd name="connsiteX0" fmla="*/ 1068457 w 1068457"/>
                  <a:gd name="connsiteY0" fmla="*/ 0 h 1490870"/>
                  <a:gd name="connsiteX1" fmla="*/ 964096 w 1068457"/>
                  <a:gd name="connsiteY1" fmla="*/ 129209 h 1490870"/>
                  <a:gd name="connsiteX2" fmla="*/ 864705 w 1068457"/>
                  <a:gd name="connsiteY2" fmla="*/ 104361 h 1490870"/>
                  <a:gd name="connsiteX3" fmla="*/ 750405 w 1068457"/>
                  <a:gd name="connsiteY3" fmla="*/ 198783 h 1490870"/>
                  <a:gd name="connsiteX4" fmla="*/ 700725 w 1068457"/>
                  <a:gd name="connsiteY4" fmla="*/ 255011 h 1490870"/>
                  <a:gd name="connsiteX5" fmla="*/ 790161 w 1068457"/>
                  <a:gd name="connsiteY5" fmla="*/ 501926 h 1490870"/>
                  <a:gd name="connsiteX6" fmla="*/ 660953 w 1068457"/>
                  <a:gd name="connsiteY6" fmla="*/ 655983 h 1490870"/>
                  <a:gd name="connsiteX7" fmla="*/ 668415 w 1068457"/>
                  <a:gd name="connsiteY7" fmla="*/ 914260 h 1490870"/>
                  <a:gd name="connsiteX8" fmla="*/ 223631 w 1068457"/>
                  <a:gd name="connsiteY8" fmla="*/ 1073426 h 1490870"/>
                  <a:gd name="connsiteX9" fmla="*/ 0 w 1068457"/>
                  <a:gd name="connsiteY9" fmla="*/ 1490870 h 1490870"/>
                  <a:gd name="connsiteX10" fmla="*/ 0 w 1068457"/>
                  <a:gd name="connsiteY10" fmla="*/ 1490870 h 1490870"/>
                  <a:gd name="connsiteX0" fmla="*/ 1101566 w 1101566"/>
                  <a:gd name="connsiteY0" fmla="*/ 0 h 1490870"/>
                  <a:gd name="connsiteX1" fmla="*/ 997205 w 1101566"/>
                  <a:gd name="connsiteY1" fmla="*/ 129209 h 1490870"/>
                  <a:gd name="connsiteX2" fmla="*/ 897814 w 1101566"/>
                  <a:gd name="connsiteY2" fmla="*/ 104361 h 1490870"/>
                  <a:gd name="connsiteX3" fmla="*/ 783514 w 1101566"/>
                  <a:gd name="connsiteY3" fmla="*/ 198783 h 1490870"/>
                  <a:gd name="connsiteX4" fmla="*/ 733834 w 1101566"/>
                  <a:gd name="connsiteY4" fmla="*/ 255011 h 1490870"/>
                  <a:gd name="connsiteX5" fmla="*/ 823270 w 1101566"/>
                  <a:gd name="connsiteY5" fmla="*/ 501926 h 1490870"/>
                  <a:gd name="connsiteX6" fmla="*/ 694062 w 1101566"/>
                  <a:gd name="connsiteY6" fmla="*/ 655983 h 1490870"/>
                  <a:gd name="connsiteX7" fmla="*/ 701524 w 1101566"/>
                  <a:gd name="connsiteY7" fmla="*/ 914260 h 1490870"/>
                  <a:gd name="connsiteX8" fmla="*/ 256740 w 1101566"/>
                  <a:gd name="connsiteY8" fmla="*/ 1073426 h 1490870"/>
                  <a:gd name="connsiteX9" fmla="*/ 33109 w 1101566"/>
                  <a:gd name="connsiteY9" fmla="*/ 1490870 h 1490870"/>
                  <a:gd name="connsiteX10" fmla="*/ 0 w 1101566"/>
                  <a:gd name="connsiteY10" fmla="*/ 1473262 h 1490870"/>
                  <a:gd name="connsiteX0" fmla="*/ 1101566 w 1101566"/>
                  <a:gd name="connsiteY0" fmla="*/ 0 h 1490870"/>
                  <a:gd name="connsiteX1" fmla="*/ 997205 w 1101566"/>
                  <a:gd name="connsiteY1" fmla="*/ 129209 h 1490870"/>
                  <a:gd name="connsiteX2" fmla="*/ 897814 w 1101566"/>
                  <a:gd name="connsiteY2" fmla="*/ 104361 h 1490870"/>
                  <a:gd name="connsiteX3" fmla="*/ 783514 w 1101566"/>
                  <a:gd name="connsiteY3" fmla="*/ 198783 h 1490870"/>
                  <a:gd name="connsiteX4" fmla="*/ 733834 w 1101566"/>
                  <a:gd name="connsiteY4" fmla="*/ 255011 h 1490870"/>
                  <a:gd name="connsiteX5" fmla="*/ 823270 w 1101566"/>
                  <a:gd name="connsiteY5" fmla="*/ 501926 h 1490870"/>
                  <a:gd name="connsiteX6" fmla="*/ 694062 w 1101566"/>
                  <a:gd name="connsiteY6" fmla="*/ 655983 h 1490870"/>
                  <a:gd name="connsiteX7" fmla="*/ 701524 w 1101566"/>
                  <a:gd name="connsiteY7" fmla="*/ 914260 h 1490870"/>
                  <a:gd name="connsiteX8" fmla="*/ 205006 w 1101566"/>
                  <a:gd name="connsiteY8" fmla="*/ 1080029 h 1490870"/>
                  <a:gd name="connsiteX9" fmla="*/ 33109 w 1101566"/>
                  <a:gd name="connsiteY9" fmla="*/ 1490870 h 1490870"/>
                  <a:gd name="connsiteX10" fmla="*/ 0 w 1101566"/>
                  <a:gd name="connsiteY10" fmla="*/ 1473262 h 1490870"/>
                  <a:gd name="connsiteX0" fmla="*/ 1101566 w 1101566"/>
                  <a:gd name="connsiteY0" fmla="*/ 0 h 1473262"/>
                  <a:gd name="connsiteX1" fmla="*/ 997205 w 1101566"/>
                  <a:gd name="connsiteY1" fmla="*/ 129209 h 1473262"/>
                  <a:gd name="connsiteX2" fmla="*/ 897814 w 1101566"/>
                  <a:gd name="connsiteY2" fmla="*/ 104361 h 1473262"/>
                  <a:gd name="connsiteX3" fmla="*/ 783514 w 1101566"/>
                  <a:gd name="connsiteY3" fmla="*/ 198783 h 1473262"/>
                  <a:gd name="connsiteX4" fmla="*/ 733834 w 1101566"/>
                  <a:gd name="connsiteY4" fmla="*/ 255011 h 1473262"/>
                  <a:gd name="connsiteX5" fmla="*/ 823270 w 1101566"/>
                  <a:gd name="connsiteY5" fmla="*/ 501926 h 1473262"/>
                  <a:gd name="connsiteX6" fmla="*/ 694062 w 1101566"/>
                  <a:gd name="connsiteY6" fmla="*/ 655983 h 1473262"/>
                  <a:gd name="connsiteX7" fmla="*/ 701524 w 1101566"/>
                  <a:gd name="connsiteY7" fmla="*/ 914260 h 1473262"/>
                  <a:gd name="connsiteX8" fmla="*/ 205006 w 1101566"/>
                  <a:gd name="connsiteY8" fmla="*/ 1080029 h 1473262"/>
                  <a:gd name="connsiteX9" fmla="*/ 6207 w 1101566"/>
                  <a:gd name="connsiteY9" fmla="*/ 1468861 h 1473262"/>
                  <a:gd name="connsiteX10" fmla="*/ 0 w 1101566"/>
                  <a:gd name="connsiteY10" fmla="*/ 1473262 h 147326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1101566" h="1473262">
                    <a:moveTo>
                      <a:pt x="1101566" y="0"/>
                    </a:moveTo>
                    <a:lnTo>
                      <a:pt x="997205" y="129209"/>
                    </a:lnTo>
                    <a:lnTo>
                      <a:pt x="897814" y="104361"/>
                    </a:lnTo>
                    <a:lnTo>
                      <a:pt x="783514" y="198783"/>
                    </a:lnTo>
                    <a:lnTo>
                      <a:pt x="733834" y="255011"/>
                    </a:lnTo>
                    <a:lnTo>
                      <a:pt x="823270" y="501926"/>
                    </a:lnTo>
                    <a:lnTo>
                      <a:pt x="694062" y="655983"/>
                    </a:lnTo>
                    <a:lnTo>
                      <a:pt x="701524" y="914260"/>
                    </a:lnTo>
                    <a:lnTo>
                      <a:pt x="205006" y="1080029"/>
                    </a:lnTo>
                    <a:lnTo>
                      <a:pt x="6207" y="1468861"/>
                    </a:lnTo>
                    <a:lnTo>
                      <a:pt x="0" y="1473262"/>
                    </a:lnTo>
                  </a:path>
                </a:pathLst>
              </a:cu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en-GB"/>
              </a:p>
            </p:txBody>
          </p:sp>
          <p:pic>
            <p:nvPicPr>
              <p:cNvPr id="18" name="Grafik 17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29455" y="2122805"/>
                <a:ext cx="2338628" cy="1624754"/>
              </a:xfrm>
              <a:prstGeom prst="rect">
                <a:avLst/>
              </a:prstGeom>
            </p:spPr>
          </p:pic>
          <p:sp>
            <p:nvSpPr>
              <p:cNvPr id="19" name="Textfeld 34"/>
              <p:cNvSpPr txBox="1"/>
              <p:nvPr/>
            </p:nvSpPr>
            <p:spPr>
              <a:xfrm>
                <a:off x="3230684" y="2435134"/>
                <a:ext cx="357679" cy="1353906"/>
              </a:xfrm>
              <a:prstGeom prst="rect">
                <a:avLst/>
              </a:prstGeom>
              <a:noFill/>
              <a:scene3d>
                <a:camera prst="orthographicFront">
                  <a:rot lat="0" lon="0" rev="0"/>
                </a:camera>
                <a:lightRig rig="threePt" dir="t"/>
              </a:scene3d>
            </p:spPr>
            <p:txBody>
              <a:bodyPr vert="vert270" wrap="square" rtlCol="0">
                <a:noAutofit/>
              </a:bodyPr>
              <a:lstStyle/>
              <a:p>
                <a:pPr>
                  <a:lnSpc>
                    <a:spcPct val="150000"/>
                  </a:lnSpc>
                  <a:spcAft>
                    <a:spcPts val="0"/>
                  </a:spcAft>
                </a:pPr>
                <a:r>
                  <a:rPr lang="de-DE" sz="1000" dirty="0" smtClean="0">
                    <a:solidFill>
                      <a:srgbClr val="000000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„</a:t>
                </a:r>
                <a:r>
                  <a:rPr lang="de-DE" sz="1000" kern="1200" dirty="0" smtClean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Pathological“ </a:t>
                </a:r>
                <a:r>
                  <a:rPr lang="de-DE" sz="1000" kern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+ T4</a:t>
                </a:r>
                <a:endParaRPr lang="en-GB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20" name="Freihandform 19"/>
              <p:cNvSpPr/>
              <p:nvPr/>
            </p:nvSpPr>
            <p:spPr>
              <a:xfrm>
                <a:off x="5253619" y="2809586"/>
                <a:ext cx="459179" cy="734270"/>
              </a:xfrm>
              <a:custGeom>
                <a:avLst/>
                <a:gdLst>
                  <a:gd name="connsiteX0" fmla="*/ 0 w 849795"/>
                  <a:gd name="connsiteY0" fmla="*/ 293205 h 924339"/>
                  <a:gd name="connsiteX1" fmla="*/ 134178 w 849795"/>
                  <a:gd name="connsiteY1" fmla="*/ 412474 h 924339"/>
                  <a:gd name="connsiteX2" fmla="*/ 278295 w 849795"/>
                  <a:gd name="connsiteY2" fmla="*/ 536713 h 924339"/>
                  <a:gd name="connsiteX3" fmla="*/ 323021 w 849795"/>
                  <a:gd name="connsiteY3" fmla="*/ 501926 h 924339"/>
                  <a:gd name="connsiteX4" fmla="*/ 541682 w 849795"/>
                  <a:gd name="connsiteY4" fmla="*/ 839857 h 924339"/>
                  <a:gd name="connsiteX5" fmla="*/ 770282 w 849795"/>
                  <a:gd name="connsiteY5" fmla="*/ 924339 h 924339"/>
                  <a:gd name="connsiteX6" fmla="*/ 810039 w 849795"/>
                  <a:gd name="connsiteY6" fmla="*/ 660952 h 924339"/>
                  <a:gd name="connsiteX7" fmla="*/ 780221 w 849795"/>
                  <a:gd name="connsiteY7" fmla="*/ 392596 h 924339"/>
                  <a:gd name="connsiteX8" fmla="*/ 849795 w 849795"/>
                  <a:gd name="connsiteY8" fmla="*/ 218661 h 924339"/>
                  <a:gd name="connsiteX9" fmla="*/ 805069 w 849795"/>
                  <a:gd name="connsiteY9" fmla="*/ 104361 h 924339"/>
                  <a:gd name="connsiteX10" fmla="*/ 790160 w 849795"/>
                  <a:gd name="connsiteY10" fmla="*/ 0 h 924339"/>
                  <a:gd name="connsiteX11" fmla="*/ 0 w 849795"/>
                  <a:gd name="connsiteY11" fmla="*/ 293205 h 924339"/>
                  <a:gd name="connsiteX0" fmla="*/ 185050 w 715617"/>
                  <a:gd name="connsiteY0" fmla="*/ 485427 h 924339"/>
                  <a:gd name="connsiteX1" fmla="*/ 0 w 715617"/>
                  <a:gd name="connsiteY1" fmla="*/ 412474 h 924339"/>
                  <a:gd name="connsiteX2" fmla="*/ 144117 w 715617"/>
                  <a:gd name="connsiteY2" fmla="*/ 536713 h 924339"/>
                  <a:gd name="connsiteX3" fmla="*/ 188843 w 715617"/>
                  <a:gd name="connsiteY3" fmla="*/ 501926 h 924339"/>
                  <a:gd name="connsiteX4" fmla="*/ 407504 w 715617"/>
                  <a:gd name="connsiteY4" fmla="*/ 839857 h 924339"/>
                  <a:gd name="connsiteX5" fmla="*/ 636104 w 715617"/>
                  <a:gd name="connsiteY5" fmla="*/ 924339 h 924339"/>
                  <a:gd name="connsiteX6" fmla="*/ 675861 w 715617"/>
                  <a:gd name="connsiteY6" fmla="*/ 660952 h 924339"/>
                  <a:gd name="connsiteX7" fmla="*/ 646043 w 715617"/>
                  <a:gd name="connsiteY7" fmla="*/ 392596 h 924339"/>
                  <a:gd name="connsiteX8" fmla="*/ 715617 w 715617"/>
                  <a:gd name="connsiteY8" fmla="*/ 218661 h 924339"/>
                  <a:gd name="connsiteX9" fmla="*/ 670891 w 715617"/>
                  <a:gd name="connsiteY9" fmla="*/ 104361 h 924339"/>
                  <a:gd name="connsiteX10" fmla="*/ 655982 w 715617"/>
                  <a:gd name="connsiteY10" fmla="*/ 0 h 924339"/>
                  <a:gd name="connsiteX11" fmla="*/ 185050 w 715617"/>
                  <a:gd name="connsiteY11" fmla="*/ 485427 h 924339"/>
                  <a:gd name="connsiteX0" fmla="*/ 185050 w 715617"/>
                  <a:gd name="connsiteY0" fmla="*/ 485427 h 924339"/>
                  <a:gd name="connsiteX1" fmla="*/ 0 w 715617"/>
                  <a:gd name="connsiteY1" fmla="*/ 412474 h 924339"/>
                  <a:gd name="connsiteX2" fmla="*/ 144117 w 715617"/>
                  <a:gd name="connsiteY2" fmla="*/ 536713 h 924339"/>
                  <a:gd name="connsiteX3" fmla="*/ 188843 w 715617"/>
                  <a:gd name="connsiteY3" fmla="*/ 501926 h 924339"/>
                  <a:gd name="connsiteX4" fmla="*/ 407504 w 715617"/>
                  <a:gd name="connsiteY4" fmla="*/ 839857 h 924339"/>
                  <a:gd name="connsiteX5" fmla="*/ 636104 w 715617"/>
                  <a:gd name="connsiteY5" fmla="*/ 924339 h 924339"/>
                  <a:gd name="connsiteX6" fmla="*/ 675861 w 715617"/>
                  <a:gd name="connsiteY6" fmla="*/ 660952 h 924339"/>
                  <a:gd name="connsiteX7" fmla="*/ 646043 w 715617"/>
                  <a:gd name="connsiteY7" fmla="*/ 392596 h 924339"/>
                  <a:gd name="connsiteX8" fmla="*/ 715617 w 715617"/>
                  <a:gd name="connsiteY8" fmla="*/ 218661 h 924339"/>
                  <a:gd name="connsiteX9" fmla="*/ 670891 w 715617"/>
                  <a:gd name="connsiteY9" fmla="*/ 104361 h 924339"/>
                  <a:gd name="connsiteX10" fmla="*/ 655982 w 715617"/>
                  <a:gd name="connsiteY10" fmla="*/ 0 h 924339"/>
                  <a:gd name="connsiteX11" fmla="*/ 185050 w 715617"/>
                  <a:gd name="connsiteY11" fmla="*/ 485427 h 924339"/>
                  <a:gd name="connsiteX0" fmla="*/ 40933 w 571500"/>
                  <a:gd name="connsiteY0" fmla="*/ 485427 h 924339"/>
                  <a:gd name="connsiteX1" fmla="*/ 0 w 571500"/>
                  <a:gd name="connsiteY1" fmla="*/ 536713 h 924339"/>
                  <a:gd name="connsiteX2" fmla="*/ 44726 w 571500"/>
                  <a:gd name="connsiteY2" fmla="*/ 501926 h 924339"/>
                  <a:gd name="connsiteX3" fmla="*/ 263387 w 571500"/>
                  <a:gd name="connsiteY3" fmla="*/ 839857 h 924339"/>
                  <a:gd name="connsiteX4" fmla="*/ 491987 w 571500"/>
                  <a:gd name="connsiteY4" fmla="*/ 924339 h 924339"/>
                  <a:gd name="connsiteX5" fmla="*/ 531744 w 571500"/>
                  <a:gd name="connsiteY5" fmla="*/ 660952 h 924339"/>
                  <a:gd name="connsiteX6" fmla="*/ 501926 w 571500"/>
                  <a:gd name="connsiteY6" fmla="*/ 392596 h 924339"/>
                  <a:gd name="connsiteX7" fmla="*/ 571500 w 571500"/>
                  <a:gd name="connsiteY7" fmla="*/ 218661 h 924339"/>
                  <a:gd name="connsiteX8" fmla="*/ 526774 w 571500"/>
                  <a:gd name="connsiteY8" fmla="*/ 104361 h 924339"/>
                  <a:gd name="connsiteX9" fmla="*/ 511865 w 571500"/>
                  <a:gd name="connsiteY9" fmla="*/ 0 h 924339"/>
                  <a:gd name="connsiteX10" fmla="*/ 40933 w 571500"/>
                  <a:gd name="connsiteY10" fmla="*/ 485427 h 924339"/>
                  <a:gd name="connsiteX0" fmla="*/ 0 w 530567"/>
                  <a:gd name="connsiteY0" fmla="*/ 485427 h 924339"/>
                  <a:gd name="connsiteX1" fmla="*/ 3793 w 530567"/>
                  <a:gd name="connsiteY1" fmla="*/ 501926 h 924339"/>
                  <a:gd name="connsiteX2" fmla="*/ 222454 w 530567"/>
                  <a:gd name="connsiteY2" fmla="*/ 839857 h 924339"/>
                  <a:gd name="connsiteX3" fmla="*/ 451054 w 530567"/>
                  <a:gd name="connsiteY3" fmla="*/ 924339 h 924339"/>
                  <a:gd name="connsiteX4" fmla="*/ 490811 w 530567"/>
                  <a:gd name="connsiteY4" fmla="*/ 660952 h 924339"/>
                  <a:gd name="connsiteX5" fmla="*/ 460993 w 530567"/>
                  <a:gd name="connsiteY5" fmla="*/ 392596 h 924339"/>
                  <a:gd name="connsiteX6" fmla="*/ 530567 w 530567"/>
                  <a:gd name="connsiteY6" fmla="*/ 218661 h 924339"/>
                  <a:gd name="connsiteX7" fmla="*/ 485841 w 530567"/>
                  <a:gd name="connsiteY7" fmla="*/ 104361 h 924339"/>
                  <a:gd name="connsiteX8" fmla="*/ 470932 w 530567"/>
                  <a:gd name="connsiteY8" fmla="*/ 0 h 924339"/>
                  <a:gd name="connsiteX9" fmla="*/ 0 w 530567"/>
                  <a:gd name="connsiteY9" fmla="*/ 485427 h 924339"/>
                  <a:gd name="connsiteX0" fmla="*/ 0 w 532627"/>
                  <a:gd name="connsiteY0" fmla="*/ 400492 h 924339"/>
                  <a:gd name="connsiteX1" fmla="*/ 5853 w 532627"/>
                  <a:gd name="connsiteY1" fmla="*/ 501926 h 924339"/>
                  <a:gd name="connsiteX2" fmla="*/ 224514 w 532627"/>
                  <a:gd name="connsiteY2" fmla="*/ 839857 h 924339"/>
                  <a:gd name="connsiteX3" fmla="*/ 453114 w 532627"/>
                  <a:gd name="connsiteY3" fmla="*/ 924339 h 924339"/>
                  <a:gd name="connsiteX4" fmla="*/ 492871 w 532627"/>
                  <a:gd name="connsiteY4" fmla="*/ 660952 h 924339"/>
                  <a:gd name="connsiteX5" fmla="*/ 463053 w 532627"/>
                  <a:gd name="connsiteY5" fmla="*/ 392596 h 924339"/>
                  <a:gd name="connsiteX6" fmla="*/ 532627 w 532627"/>
                  <a:gd name="connsiteY6" fmla="*/ 218661 h 924339"/>
                  <a:gd name="connsiteX7" fmla="*/ 487901 w 532627"/>
                  <a:gd name="connsiteY7" fmla="*/ 104361 h 924339"/>
                  <a:gd name="connsiteX8" fmla="*/ 472992 w 532627"/>
                  <a:gd name="connsiteY8" fmla="*/ 0 h 924339"/>
                  <a:gd name="connsiteX9" fmla="*/ 0 w 532627"/>
                  <a:gd name="connsiteY9" fmla="*/ 400492 h 92433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532627" h="924339">
                    <a:moveTo>
                      <a:pt x="0" y="400492"/>
                    </a:moveTo>
                    <a:lnTo>
                      <a:pt x="5853" y="501926"/>
                    </a:lnTo>
                    <a:lnTo>
                      <a:pt x="224514" y="839857"/>
                    </a:lnTo>
                    <a:lnTo>
                      <a:pt x="453114" y="924339"/>
                    </a:lnTo>
                    <a:lnTo>
                      <a:pt x="492871" y="660952"/>
                    </a:lnTo>
                    <a:lnTo>
                      <a:pt x="463053" y="392596"/>
                    </a:lnTo>
                    <a:lnTo>
                      <a:pt x="532627" y="218661"/>
                    </a:lnTo>
                    <a:lnTo>
                      <a:pt x="487901" y="104361"/>
                    </a:lnTo>
                    <a:lnTo>
                      <a:pt x="472992" y="0"/>
                    </a:lnTo>
                    <a:lnTo>
                      <a:pt x="0" y="400492"/>
                    </a:lnTo>
                    <a:close/>
                  </a:path>
                </a:pathLst>
              </a:custGeom>
              <a:noFill/>
              <a:ln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en-GB"/>
              </a:p>
            </p:txBody>
          </p:sp>
          <p:sp>
            <p:nvSpPr>
              <p:cNvPr id="21" name="Freihandform 20"/>
              <p:cNvSpPr/>
              <p:nvPr/>
            </p:nvSpPr>
            <p:spPr>
              <a:xfrm>
                <a:off x="5202419" y="3146244"/>
                <a:ext cx="379018" cy="426611"/>
              </a:xfrm>
              <a:custGeom>
                <a:avLst/>
                <a:gdLst>
                  <a:gd name="connsiteX0" fmla="*/ 0 w 750404"/>
                  <a:gd name="connsiteY0" fmla="*/ 0 h 621195"/>
                  <a:gd name="connsiteX1" fmla="*/ 258417 w 750404"/>
                  <a:gd name="connsiteY1" fmla="*/ 243508 h 621195"/>
                  <a:gd name="connsiteX2" fmla="*/ 327991 w 750404"/>
                  <a:gd name="connsiteY2" fmla="*/ 223630 h 621195"/>
                  <a:gd name="connsiteX3" fmla="*/ 511865 w 750404"/>
                  <a:gd name="connsiteY3" fmla="*/ 491987 h 621195"/>
                  <a:gd name="connsiteX4" fmla="*/ 536713 w 750404"/>
                  <a:gd name="connsiteY4" fmla="*/ 536713 h 621195"/>
                  <a:gd name="connsiteX5" fmla="*/ 750404 w 750404"/>
                  <a:gd name="connsiteY5" fmla="*/ 621195 h 621195"/>
                  <a:gd name="connsiteX6" fmla="*/ 750404 w 750404"/>
                  <a:gd name="connsiteY6" fmla="*/ 621195 h 621195"/>
                  <a:gd name="connsiteX7" fmla="*/ 750404 w 750404"/>
                  <a:gd name="connsiteY7" fmla="*/ 621195 h 621195"/>
                  <a:gd name="connsiteX0" fmla="*/ 0 w 491987"/>
                  <a:gd name="connsiteY0" fmla="*/ 19878 h 397565"/>
                  <a:gd name="connsiteX1" fmla="*/ 69574 w 491987"/>
                  <a:gd name="connsiteY1" fmla="*/ 0 h 397565"/>
                  <a:gd name="connsiteX2" fmla="*/ 253448 w 491987"/>
                  <a:gd name="connsiteY2" fmla="*/ 268357 h 397565"/>
                  <a:gd name="connsiteX3" fmla="*/ 278296 w 491987"/>
                  <a:gd name="connsiteY3" fmla="*/ 313083 h 397565"/>
                  <a:gd name="connsiteX4" fmla="*/ 491987 w 491987"/>
                  <a:gd name="connsiteY4" fmla="*/ 397565 h 397565"/>
                  <a:gd name="connsiteX5" fmla="*/ 491987 w 491987"/>
                  <a:gd name="connsiteY5" fmla="*/ 397565 h 397565"/>
                  <a:gd name="connsiteX6" fmla="*/ 491987 w 491987"/>
                  <a:gd name="connsiteY6" fmla="*/ 397565 h 397565"/>
                  <a:gd name="connsiteX0" fmla="*/ 10748 w 422413"/>
                  <a:gd name="connsiteY0" fmla="*/ 0 h 545322"/>
                  <a:gd name="connsiteX1" fmla="*/ 0 w 422413"/>
                  <a:gd name="connsiteY1" fmla="*/ 147757 h 545322"/>
                  <a:gd name="connsiteX2" fmla="*/ 183874 w 422413"/>
                  <a:gd name="connsiteY2" fmla="*/ 416114 h 545322"/>
                  <a:gd name="connsiteX3" fmla="*/ 208722 w 422413"/>
                  <a:gd name="connsiteY3" fmla="*/ 460840 h 545322"/>
                  <a:gd name="connsiteX4" fmla="*/ 422413 w 422413"/>
                  <a:gd name="connsiteY4" fmla="*/ 545322 h 545322"/>
                  <a:gd name="connsiteX5" fmla="*/ 422413 w 422413"/>
                  <a:gd name="connsiteY5" fmla="*/ 545322 h 545322"/>
                  <a:gd name="connsiteX6" fmla="*/ 422413 w 422413"/>
                  <a:gd name="connsiteY6" fmla="*/ 545322 h 545322"/>
                  <a:gd name="connsiteX0" fmla="*/ 0 w 439644"/>
                  <a:gd name="connsiteY0" fmla="*/ 0 h 537041"/>
                  <a:gd name="connsiteX1" fmla="*/ 17231 w 439644"/>
                  <a:gd name="connsiteY1" fmla="*/ 139476 h 537041"/>
                  <a:gd name="connsiteX2" fmla="*/ 201105 w 439644"/>
                  <a:gd name="connsiteY2" fmla="*/ 407833 h 537041"/>
                  <a:gd name="connsiteX3" fmla="*/ 225953 w 439644"/>
                  <a:gd name="connsiteY3" fmla="*/ 452559 h 537041"/>
                  <a:gd name="connsiteX4" fmla="*/ 439644 w 439644"/>
                  <a:gd name="connsiteY4" fmla="*/ 537041 h 537041"/>
                  <a:gd name="connsiteX5" fmla="*/ 439644 w 439644"/>
                  <a:gd name="connsiteY5" fmla="*/ 537041 h 537041"/>
                  <a:gd name="connsiteX6" fmla="*/ 439644 w 439644"/>
                  <a:gd name="connsiteY6" fmla="*/ 537041 h 53704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439644" h="537041">
                    <a:moveTo>
                      <a:pt x="0" y="0"/>
                    </a:moveTo>
                    <a:lnTo>
                      <a:pt x="17231" y="139476"/>
                    </a:lnTo>
                    <a:lnTo>
                      <a:pt x="201105" y="407833"/>
                    </a:lnTo>
                    <a:lnTo>
                      <a:pt x="225953" y="452559"/>
                    </a:lnTo>
                    <a:lnTo>
                      <a:pt x="439644" y="537041"/>
                    </a:lnTo>
                    <a:lnTo>
                      <a:pt x="439644" y="537041"/>
                    </a:lnTo>
                    <a:lnTo>
                      <a:pt x="439644" y="537041"/>
                    </a:lnTo>
                  </a:path>
                </a:pathLst>
              </a:custGeom>
              <a:noFill/>
              <a:ln w="19050">
                <a:solidFill>
                  <a:srgbClr val="00B0F0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en-GB"/>
              </a:p>
            </p:txBody>
          </p:sp>
          <p:sp>
            <p:nvSpPr>
              <p:cNvPr id="22" name="Textfeld 15"/>
              <p:cNvSpPr txBox="1"/>
              <p:nvPr/>
            </p:nvSpPr>
            <p:spPr>
              <a:xfrm>
                <a:off x="697201" y="332656"/>
                <a:ext cx="418139" cy="32970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>
                  <a:lnSpc>
                    <a:spcPct val="150000"/>
                  </a:lnSpc>
                  <a:spcAft>
                    <a:spcPts val="0"/>
                  </a:spcAft>
                </a:pPr>
                <a:r>
                  <a:rPr lang="de-DE" sz="1200" b="1" dirty="0" smtClean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A</a:t>
                </a:r>
                <a:endParaRPr lang="en-GB" sz="12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3" name="Gerader Verbinder 22"/>
              <p:cNvCxnSpPr>
                <a:cxnSpLocks noChangeShapeType="1"/>
              </p:cNvCxnSpPr>
              <p:nvPr/>
            </p:nvCxnSpPr>
            <p:spPr bwMode="auto">
              <a:xfrm>
                <a:off x="5564377" y="3639718"/>
                <a:ext cx="284222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24" name="Textfeld 87"/>
              <p:cNvSpPr txBox="1"/>
              <p:nvPr/>
            </p:nvSpPr>
            <p:spPr>
              <a:xfrm>
                <a:off x="918801" y="354124"/>
                <a:ext cx="675335" cy="42340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>
                  <a:lnSpc>
                    <a:spcPct val="150000"/>
                  </a:lnSpc>
                  <a:spcAft>
                    <a:spcPts val="0"/>
                  </a:spcAft>
                </a:pPr>
                <a:r>
                  <a:rPr lang="de-DE" sz="1000" b="1" dirty="0" smtClean="0">
                    <a:solidFill>
                      <a:srgbClr val="000000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PAS</a:t>
                </a:r>
                <a:endParaRPr lang="de-DE" sz="10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feld 15"/>
              <p:cNvSpPr txBox="1"/>
              <p:nvPr/>
            </p:nvSpPr>
            <p:spPr>
              <a:xfrm>
                <a:off x="697201" y="3912848"/>
                <a:ext cx="418139" cy="32970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>
                  <a:lnSpc>
                    <a:spcPct val="150000"/>
                  </a:lnSpc>
                  <a:spcAft>
                    <a:spcPts val="0"/>
                  </a:spcAft>
                </a:pPr>
                <a:r>
                  <a:rPr lang="de-DE" sz="1200" b="1" dirty="0" smtClean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B</a:t>
                </a:r>
                <a:endParaRPr lang="en-GB" sz="12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Freihandform 25"/>
              <p:cNvSpPr/>
              <p:nvPr/>
            </p:nvSpPr>
            <p:spPr>
              <a:xfrm>
                <a:off x="5185135" y="1437766"/>
                <a:ext cx="225425" cy="74613"/>
              </a:xfrm>
              <a:custGeom>
                <a:avLst/>
                <a:gdLst>
                  <a:gd name="connsiteX0" fmla="*/ 0 w 225425"/>
                  <a:gd name="connsiteY0" fmla="*/ 20638 h 74613"/>
                  <a:gd name="connsiteX1" fmla="*/ 58738 w 225425"/>
                  <a:gd name="connsiteY1" fmla="*/ 0 h 74613"/>
                  <a:gd name="connsiteX2" fmla="*/ 225425 w 225425"/>
                  <a:gd name="connsiteY2" fmla="*/ 74613 h 74613"/>
                  <a:gd name="connsiteX3" fmla="*/ 225425 w 225425"/>
                  <a:gd name="connsiteY3" fmla="*/ 74613 h 7461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225425" h="74613">
                    <a:moveTo>
                      <a:pt x="0" y="20638"/>
                    </a:moveTo>
                    <a:lnTo>
                      <a:pt x="58738" y="0"/>
                    </a:lnTo>
                    <a:lnTo>
                      <a:pt x="225425" y="74613"/>
                    </a:lnTo>
                    <a:lnTo>
                      <a:pt x="225425" y="74613"/>
                    </a:lnTo>
                  </a:path>
                </a:pathLst>
              </a:custGeom>
              <a:noFill/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27" name="Freihandform 26"/>
              <p:cNvSpPr/>
              <p:nvPr/>
            </p:nvSpPr>
            <p:spPr>
              <a:xfrm>
                <a:off x="5186723" y="1342516"/>
                <a:ext cx="317500" cy="147638"/>
              </a:xfrm>
              <a:custGeom>
                <a:avLst/>
                <a:gdLst>
                  <a:gd name="connsiteX0" fmla="*/ 0 w 317500"/>
                  <a:gd name="connsiteY0" fmla="*/ 82550 h 147638"/>
                  <a:gd name="connsiteX1" fmla="*/ 57150 w 317500"/>
                  <a:gd name="connsiteY1" fmla="*/ 61913 h 147638"/>
                  <a:gd name="connsiteX2" fmla="*/ 231775 w 317500"/>
                  <a:gd name="connsiteY2" fmla="*/ 147638 h 147638"/>
                  <a:gd name="connsiteX3" fmla="*/ 317500 w 317500"/>
                  <a:gd name="connsiteY3" fmla="*/ 95250 h 147638"/>
                  <a:gd name="connsiteX4" fmla="*/ 266700 w 317500"/>
                  <a:gd name="connsiteY4" fmla="*/ 39688 h 147638"/>
                  <a:gd name="connsiteX5" fmla="*/ 180975 w 317500"/>
                  <a:gd name="connsiteY5" fmla="*/ 73025 h 147638"/>
                  <a:gd name="connsiteX6" fmla="*/ 68262 w 317500"/>
                  <a:gd name="connsiteY6" fmla="*/ 0 h 147638"/>
                  <a:gd name="connsiteX7" fmla="*/ 0 w 317500"/>
                  <a:gd name="connsiteY7" fmla="*/ 82550 h 1476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317500" h="147638">
                    <a:moveTo>
                      <a:pt x="0" y="82550"/>
                    </a:moveTo>
                    <a:lnTo>
                      <a:pt x="57150" y="61913"/>
                    </a:lnTo>
                    <a:lnTo>
                      <a:pt x="231775" y="147638"/>
                    </a:lnTo>
                    <a:lnTo>
                      <a:pt x="317500" y="95250"/>
                    </a:lnTo>
                    <a:lnTo>
                      <a:pt x="266700" y="39688"/>
                    </a:lnTo>
                    <a:lnTo>
                      <a:pt x="180975" y="73025"/>
                    </a:lnTo>
                    <a:lnTo>
                      <a:pt x="68262" y="0"/>
                    </a:lnTo>
                    <a:lnTo>
                      <a:pt x="0" y="82550"/>
                    </a:lnTo>
                    <a:close/>
                  </a:path>
                </a:pathLst>
              </a:custGeom>
              <a:noFill/>
              <a:ln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28" name="Textfeld 27"/>
              <p:cNvSpPr txBox="1"/>
              <p:nvPr/>
            </p:nvSpPr>
            <p:spPr>
              <a:xfrm>
                <a:off x="983432" y="642156"/>
                <a:ext cx="61382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PI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feld 28"/>
              <p:cNvSpPr txBox="1"/>
              <p:nvPr/>
            </p:nvSpPr>
            <p:spPr>
              <a:xfrm>
                <a:off x="983432" y="1188023"/>
                <a:ext cx="61382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ER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feld 29"/>
              <p:cNvSpPr txBox="1"/>
              <p:nvPr/>
            </p:nvSpPr>
            <p:spPr>
              <a:xfrm>
                <a:off x="2458232" y="1836095"/>
                <a:ext cx="45555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T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feld 30"/>
              <p:cNvSpPr txBox="1"/>
              <p:nvPr/>
            </p:nvSpPr>
            <p:spPr>
              <a:xfrm>
                <a:off x="1450120" y="3564287"/>
                <a:ext cx="45555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T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feld 31"/>
              <p:cNvSpPr txBox="1"/>
              <p:nvPr/>
            </p:nvSpPr>
            <p:spPr>
              <a:xfrm>
                <a:off x="5675090" y="3348263"/>
                <a:ext cx="45555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T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feld 32"/>
              <p:cNvSpPr txBox="1"/>
              <p:nvPr/>
            </p:nvSpPr>
            <p:spPr>
              <a:xfrm>
                <a:off x="5482568" y="1290228"/>
                <a:ext cx="45555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T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feld 33"/>
              <p:cNvSpPr txBox="1"/>
              <p:nvPr/>
            </p:nvSpPr>
            <p:spPr>
              <a:xfrm>
                <a:off x="2132443" y="2154324"/>
                <a:ext cx="61382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PI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feld 34"/>
              <p:cNvSpPr txBox="1"/>
              <p:nvPr/>
            </p:nvSpPr>
            <p:spPr>
              <a:xfrm>
                <a:off x="3503712" y="1362236"/>
                <a:ext cx="61382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ER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Textfeld 35"/>
              <p:cNvSpPr txBox="1"/>
              <p:nvPr/>
            </p:nvSpPr>
            <p:spPr>
              <a:xfrm>
                <a:off x="1127448" y="2738772"/>
                <a:ext cx="61382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ER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feld 36"/>
              <p:cNvSpPr txBox="1"/>
              <p:nvPr/>
            </p:nvSpPr>
            <p:spPr>
              <a:xfrm>
                <a:off x="3503712" y="2636912"/>
                <a:ext cx="61382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ER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feld 37"/>
              <p:cNvSpPr txBox="1"/>
              <p:nvPr/>
            </p:nvSpPr>
            <p:spPr>
              <a:xfrm>
                <a:off x="3465955" y="980728"/>
                <a:ext cx="61382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PI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feld 38"/>
              <p:cNvSpPr txBox="1"/>
              <p:nvPr/>
            </p:nvSpPr>
            <p:spPr>
              <a:xfrm>
                <a:off x="3503712" y="2132856"/>
                <a:ext cx="61382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PI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0" name="Gruppieren 39"/>
              <p:cNvGrpSpPr/>
              <p:nvPr/>
            </p:nvGrpSpPr>
            <p:grpSpPr>
              <a:xfrm>
                <a:off x="4263140" y="3738500"/>
                <a:ext cx="2227540" cy="253122"/>
                <a:chOff x="4583832" y="2188671"/>
                <a:chExt cx="2227540" cy="253122"/>
              </a:xfrm>
            </p:grpSpPr>
            <p:cxnSp>
              <p:nvCxnSpPr>
                <p:cNvPr id="58" name="Gerader Verbinder 57"/>
                <p:cNvCxnSpPr/>
                <p:nvPr/>
              </p:nvCxnSpPr>
              <p:spPr>
                <a:xfrm>
                  <a:off x="5519936" y="2315253"/>
                  <a:ext cx="288032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Gerader Verbinder 58"/>
                <p:cNvCxnSpPr/>
                <p:nvPr/>
              </p:nvCxnSpPr>
              <p:spPr>
                <a:xfrm>
                  <a:off x="4583832" y="2315253"/>
                  <a:ext cx="288000" cy="0"/>
                </a:xfrm>
                <a:prstGeom prst="line">
                  <a:avLst/>
                </a:prstGeom>
                <a:ln w="12700">
                  <a:solidFill>
                    <a:srgbClr val="0070C0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0" name="Textfeld 59"/>
                <p:cNvSpPr txBox="1"/>
                <p:nvPr/>
              </p:nvSpPr>
              <p:spPr>
                <a:xfrm>
                  <a:off x="5803260" y="2195572"/>
                  <a:ext cx="100811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0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ength</a:t>
                  </a:r>
                  <a:endParaRPr lang="en-GB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Textfeld 60"/>
                <p:cNvSpPr txBox="1"/>
                <p:nvPr/>
              </p:nvSpPr>
              <p:spPr>
                <a:xfrm>
                  <a:off x="4852985" y="2188671"/>
                  <a:ext cx="594943" cy="2531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rea</a:t>
                  </a:r>
                  <a:endParaRPr lang="en-GB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1" name="Gruppieren 40"/>
              <p:cNvGrpSpPr/>
              <p:nvPr/>
            </p:nvGrpSpPr>
            <p:grpSpPr>
              <a:xfrm>
                <a:off x="955571" y="6199792"/>
                <a:ext cx="5751133" cy="300082"/>
                <a:chOff x="1487488" y="6034308"/>
                <a:chExt cx="5751133" cy="300082"/>
              </a:xfrm>
            </p:grpSpPr>
            <p:sp>
              <p:nvSpPr>
                <p:cNvPr id="50" name="Rechteck 49"/>
                <p:cNvSpPr/>
                <p:nvPr/>
              </p:nvSpPr>
              <p:spPr>
                <a:xfrm>
                  <a:off x="1487488" y="6058087"/>
                  <a:ext cx="144012" cy="164247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en-GB"/>
                </a:p>
              </p:txBody>
            </p:sp>
            <p:sp>
              <p:nvSpPr>
                <p:cNvPr id="51" name="Textfeld 43"/>
                <p:cNvSpPr txBox="1"/>
                <p:nvPr/>
              </p:nvSpPr>
              <p:spPr>
                <a:xfrm>
                  <a:off x="1553132" y="6034308"/>
                  <a:ext cx="1407571" cy="3000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150000"/>
                    </a:lnSpc>
                    <a:spcAft>
                      <a:spcPts val="0"/>
                    </a:spcAft>
                  </a:pPr>
                  <a:r>
                    <a:rPr lang="de-DE" sz="900" kern="1200" dirty="0" smtClean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Standard medium </a:t>
                  </a:r>
                  <a:endParaRPr lang="en-GB" sz="900" dirty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52" name="Rechteck 51"/>
                <p:cNvSpPr/>
                <p:nvPr/>
              </p:nvSpPr>
              <p:spPr>
                <a:xfrm>
                  <a:off x="4052170" y="6078318"/>
                  <a:ext cx="144012" cy="144016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en-GB"/>
                </a:p>
              </p:txBody>
            </p:sp>
            <p:sp>
              <p:nvSpPr>
                <p:cNvPr id="53" name="Textfeld 52"/>
                <p:cNvSpPr txBox="1"/>
                <p:nvPr/>
              </p:nvSpPr>
              <p:spPr>
                <a:xfrm>
                  <a:off x="4129263" y="6034308"/>
                  <a:ext cx="1367752" cy="3000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150000"/>
                    </a:lnSpc>
                    <a:spcAft>
                      <a:spcPts val="0"/>
                    </a:spcAft>
                  </a:pPr>
                  <a:r>
                    <a:rPr lang="de-DE" sz="900" kern="1200" dirty="0" smtClean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„</a:t>
                  </a:r>
                  <a:r>
                    <a:rPr lang="de-DE" sz="900" kern="1200" dirty="0" err="1" smtClean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Pathological</a:t>
                  </a:r>
                  <a:r>
                    <a:rPr lang="de-DE" sz="900" kern="1200" dirty="0" smtClean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“ medium </a:t>
                  </a:r>
                  <a:endParaRPr lang="en-GB" sz="900" dirty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54" name="Rechteck 53"/>
                <p:cNvSpPr/>
                <p:nvPr/>
              </p:nvSpPr>
              <p:spPr>
                <a:xfrm>
                  <a:off x="5375134" y="6078318"/>
                  <a:ext cx="144012" cy="144016"/>
                </a:xfrm>
                <a:prstGeom prst="rect">
                  <a:avLst/>
                </a:prstGeom>
                <a:pattFill prst="pct5">
                  <a:fgClr>
                    <a:schemeClr val="tx1"/>
                  </a:fgClr>
                  <a:bgClr>
                    <a:schemeClr val="bg2">
                      <a:lumMod val="50000"/>
                    </a:schemeClr>
                  </a:bgClr>
                </a:patt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en-GB"/>
                </a:p>
              </p:txBody>
            </p:sp>
            <p:sp>
              <p:nvSpPr>
                <p:cNvPr id="55" name="Textfeld 55"/>
                <p:cNvSpPr txBox="1"/>
                <p:nvPr/>
              </p:nvSpPr>
              <p:spPr>
                <a:xfrm>
                  <a:off x="5452415" y="6034308"/>
                  <a:ext cx="1786206" cy="3000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150000"/>
                    </a:lnSpc>
                    <a:spcAft>
                      <a:spcPts val="0"/>
                    </a:spcAft>
                  </a:pPr>
                  <a:r>
                    <a:rPr lang="de-DE" sz="900" kern="1200" dirty="0" smtClean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„</a:t>
                  </a:r>
                  <a:r>
                    <a:rPr lang="de-DE" sz="900" kern="1200" dirty="0" err="1" smtClean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Pathological</a:t>
                  </a:r>
                  <a:r>
                    <a:rPr lang="de-DE" sz="900" kern="1200" dirty="0" smtClean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“ medium </a:t>
                  </a:r>
                  <a:r>
                    <a:rPr lang="de-DE" sz="900" kern="1200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+ T4</a:t>
                  </a:r>
                  <a:endParaRPr lang="en-GB" sz="900" dirty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</p:txBody>
            </p:sp>
            <p:sp>
              <p:nvSpPr>
                <p:cNvPr id="56" name="Rechteck 55"/>
                <p:cNvSpPr/>
                <p:nvPr/>
              </p:nvSpPr>
              <p:spPr>
                <a:xfrm>
                  <a:off x="2628684" y="6058087"/>
                  <a:ext cx="144012" cy="164247"/>
                </a:xfrm>
                <a:prstGeom prst="rect">
                  <a:avLst/>
                </a:prstGeom>
                <a:pattFill prst="pct5">
                  <a:fgClr>
                    <a:schemeClr val="tx1"/>
                  </a:fgClr>
                  <a:bgClr>
                    <a:schemeClr val="bg1">
                      <a:lumMod val="75000"/>
                    </a:schemeClr>
                  </a:bgClr>
                </a:patt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en-GB"/>
                </a:p>
              </p:txBody>
            </p:sp>
            <p:sp>
              <p:nvSpPr>
                <p:cNvPr id="57" name="Textfeld 57"/>
                <p:cNvSpPr txBox="1"/>
                <p:nvPr/>
              </p:nvSpPr>
              <p:spPr>
                <a:xfrm>
                  <a:off x="2700688" y="6034308"/>
                  <a:ext cx="1405537" cy="3000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150000"/>
                    </a:lnSpc>
                    <a:spcAft>
                      <a:spcPts val="0"/>
                    </a:spcAft>
                  </a:pPr>
                  <a:r>
                    <a:rPr lang="de-DE" sz="900" kern="1200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Standard </a:t>
                  </a:r>
                  <a:r>
                    <a:rPr lang="de-DE" sz="900" kern="1200" dirty="0" smtClean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medium + </a:t>
                  </a:r>
                  <a:r>
                    <a:rPr lang="de-DE" sz="900" kern="1200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</a:rPr>
                    <a:t>T4 </a:t>
                  </a:r>
                  <a:endParaRPr lang="en-GB" sz="900" dirty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2" name="Textfeld 41"/>
              <p:cNvSpPr txBox="1"/>
              <p:nvPr/>
            </p:nvSpPr>
            <p:spPr>
              <a:xfrm>
                <a:off x="1632863" y="941802"/>
                <a:ext cx="36204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L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Textfeld 42"/>
              <p:cNvSpPr txBox="1"/>
              <p:nvPr/>
            </p:nvSpPr>
            <p:spPr>
              <a:xfrm>
                <a:off x="1564567" y="2212183"/>
                <a:ext cx="36204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L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feld 43"/>
              <p:cNvSpPr txBox="1"/>
              <p:nvPr/>
            </p:nvSpPr>
            <p:spPr>
              <a:xfrm>
                <a:off x="4760483" y="1650268"/>
                <a:ext cx="36204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L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feld 44"/>
              <p:cNvSpPr txBox="1"/>
              <p:nvPr/>
            </p:nvSpPr>
            <p:spPr>
              <a:xfrm>
                <a:off x="4832491" y="3299942"/>
                <a:ext cx="36204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L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6" name="Gerade Verbindung mit Pfeil 45"/>
              <p:cNvCxnSpPr/>
              <p:nvPr/>
            </p:nvCxnSpPr>
            <p:spPr>
              <a:xfrm flipV="1">
                <a:off x="5058367" y="1451798"/>
                <a:ext cx="100691" cy="12364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Gerade Verbindung mit Pfeil 46"/>
              <p:cNvCxnSpPr/>
              <p:nvPr/>
            </p:nvCxnSpPr>
            <p:spPr>
              <a:xfrm flipV="1">
                <a:off x="5073020" y="3193006"/>
                <a:ext cx="100691" cy="12364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Gerade Verbindung mit Pfeil 47"/>
              <p:cNvCxnSpPr>
                <a:stCxn id="43" idx="3"/>
              </p:cNvCxnSpPr>
              <p:nvPr/>
            </p:nvCxnSpPr>
            <p:spPr>
              <a:xfrm>
                <a:off x="1926612" y="2335294"/>
                <a:ext cx="142251" cy="4549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Gerade Verbindung mit Pfeil 48"/>
              <p:cNvCxnSpPr/>
              <p:nvPr/>
            </p:nvCxnSpPr>
            <p:spPr>
              <a:xfrm flipV="1">
                <a:off x="1847088" y="834882"/>
                <a:ext cx="101032" cy="13482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69" name="Textfeld 68"/>
          <p:cNvSpPr txBox="1"/>
          <p:nvPr/>
        </p:nvSpPr>
        <p:spPr>
          <a:xfrm>
            <a:off x="-13063" y="6519446"/>
            <a:ext cx="29878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>
                <a:latin typeface="Arial" pitchFamily="34" charset="0"/>
                <a:cs typeface="Arial" pitchFamily="34" charset="0"/>
              </a:rPr>
              <a:t>Supplementary</a:t>
            </a:r>
            <a:r>
              <a:rPr lang="de-DE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600" b="1" dirty="0" err="1">
                <a:latin typeface="Arial" pitchFamily="34" charset="0"/>
                <a:cs typeface="Arial" pitchFamily="34" charset="0"/>
              </a:rPr>
              <a:t>figure</a:t>
            </a:r>
            <a:r>
              <a:rPr lang="de-DE" sz="1600" b="1" dirty="0">
                <a:latin typeface="Arial" pitchFamily="34" charset="0"/>
                <a:cs typeface="Arial" pitchFamily="34" charset="0"/>
              </a:rPr>
              <a:t> 2</a:t>
            </a:r>
          </a:p>
        </p:txBody>
      </p:sp>
    </p:spTree>
    <p:extLst>
      <p:ext uri="{BB962C8B-B14F-4D97-AF65-F5344CB8AC3E}">
        <p14:creationId xmlns:p14="http://schemas.microsoft.com/office/powerpoint/2010/main" val="34602369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8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702872" y="3582226"/>
            <a:ext cx="3857625" cy="2609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218184" y="3581202"/>
            <a:ext cx="3733800" cy="2590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826696" y="556402"/>
            <a:ext cx="3733800" cy="2590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279576" y="556402"/>
            <a:ext cx="3733800" cy="2590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" name="Textfeld 17"/>
          <p:cNvSpPr txBox="1"/>
          <p:nvPr/>
        </p:nvSpPr>
        <p:spPr>
          <a:xfrm>
            <a:off x="6312024" y="267676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1900372" y="3311757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0" y="6519446"/>
            <a:ext cx="29878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>
                <a:latin typeface="Arial" pitchFamily="34" charset="0"/>
                <a:cs typeface="Arial" pitchFamily="34" charset="0"/>
              </a:rPr>
              <a:t>Supplementary</a:t>
            </a:r>
            <a:r>
              <a:rPr lang="de-DE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600" b="1" dirty="0" err="1">
                <a:latin typeface="Arial" pitchFamily="34" charset="0"/>
                <a:cs typeface="Arial" pitchFamily="34" charset="0"/>
              </a:rPr>
              <a:t>figure</a:t>
            </a:r>
            <a:r>
              <a:rPr lang="de-DE" sz="16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600" b="1" dirty="0" smtClean="0">
                <a:latin typeface="Arial" pitchFamily="34" charset="0"/>
                <a:cs typeface="Arial" pitchFamily="34" charset="0"/>
              </a:rPr>
              <a:t>3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1919536" y="287421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6312024" y="3311757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1900373" y="556402"/>
            <a:ext cx="430887" cy="266429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800" b="1" dirty="0">
                <a:latin typeface="Arial" pitchFamily="34" charset="0"/>
                <a:cs typeface="Arial" pitchFamily="34" charset="0"/>
              </a:rPr>
              <a:t>Range </a:t>
            </a:r>
            <a:r>
              <a:rPr lang="de-DE" sz="800" b="1" dirty="0" err="1">
                <a:latin typeface="Arial" pitchFamily="34" charset="0"/>
                <a:cs typeface="Arial" pitchFamily="34" charset="0"/>
              </a:rPr>
              <a:t>of</a:t>
            </a:r>
            <a:r>
              <a:rPr lang="de-DE" sz="800" b="1" dirty="0">
                <a:latin typeface="Arial" pitchFamily="34" charset="0"/>
                <a:cs typeface="Arial" pitchFamily="34" charset="0"/>
              </a:rPr>
              <a:t> subepidermal</a:t>
            </a:r>
          </a:p>
          <a:p>
            <a:pPr algn="ctr"/>
            <a:r>
              <a:rPr lang="de-DE" sz="8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800" b="1" dirty="0" err="1">
                <a:latin typeface="Arial" pitchFamily="34" charset="0"/>
                <a:cs typeface="Arial" pitchFamily="34" charset="0"/>
              </a:rPr>
              <a:t>split</a:t>
            </a:r>
            <a:r>
              <a:rPr lang="de-DE" sz="8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800" b="1" dirty="0" err="1">
                <a:latin typeface="Arial" pitchFamily="34" charset="0"/>
                <a:cs typeface="Arial" pitchFamily="34" charset="0"/>
              </a:rPr>
              <a:t>formation</a:t>
            </a:r>
            <a:endParaRPr lang="de-D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6312025" y="1181353"/>
            <a:ext cx="430887" cy="1434047"/>
          </a:xfrm>
          <a:prstGeom prst="rect">
            <a:avLst/>
          </a:prstGeom>
          <a:noFill/>
          <a:scene3d>
            <a:camera prst="orthographicFront">
              <a:rot lat="0" lon="0" rev="0"/>
            </a:camera>
            <a:lightRig rig="threePt" dir="t"/>
          </a:scene3d>
        </p:spPr>
        <p:txBody>
          <a:bodyPr vert="vert270" wrap="none" rtlCol="0">
            <a:spAutoFit/>
          </a:bodyPr>
          <a:lstStyle/>
          <a:p>
            <a:pPr algn="ctr"/>
            <a:r>
              <a:rPr lang="de-DE" sz="800" b="1" dirty="0" err="1">
                <a:latin typeface="Arial" pitchFamily="34" charset="0"/>
                <a:cs typeface="Arial" pitchFamily="34" charset="0"/>
              </a:rPr>
              <a:t>Dyskeratotic</a:t>
            </a:r>
            <a:r>
              <a:rPr lang="de-DE" sz="8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800" b="1" dirty="0" err="1">
                <a:latin typeface="Arial" pitchFamily="34" charset="0"/>
                <a:cs typeface="Arial" pitchFamily="34" charset="0"/>
              </a:rPr>
              <a:t>keratinocytes</a:t>
            </a:r>
            <a:r>
              <a:rPr lang="de-DE" sz="800" b="1" dirty="0">
                <a:latin typeface="Arial" pitchFamily="34" charset="0"/>
                <a:cs typeface="Arial" pitchFamily="34" charset="0"/>
              </a:rPr>
              <a:t>/</a:t>
            </a:r>
          </a:p>
          <a:p>
            <a:pPr algn="ctr"/>
            <a:r>
              <a:rPr lang="de-DE" sz="8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800" b="1" dirty="0" err="1">
                <a:latin typeface="Arial" pitchFamily="34" charset="0"/>
                <a:cs typeface="Arial" pitchFamily="34" charset="0"/>
              </a:rPr>
              <a:t>visual</a:t>
            </a:r>
            <a:r>
              <a:rPr lang="de-DE" sz="8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800" b="1" dirty="0" err="1">
                <a:latin typeface="Arial" pitchFamily="34" charset="0"/>
                <a:cs typeface="Arial" pitchFamily="34" charset="0"/>
              </a:rPr>
              <a:t>field</a:t>
            </a:r>
            <a:endParaRPr lang="de-D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1900373" y="3934875"/>
            <a:ext cx="430887" cy="1616789"/>
          </a:xfrm>
          <a:prstGeom prst="rect">
            <a:avLst/>
          </a:prstGeom>
          <a:noFill/>
          <a:scene3d>
            <a:camera prst="orthographicFront">
              <a:rot lat="0" lon="0" rev="0"/>
            </a:camera>
            <a:lightRig rig="threePt" dir="t"/>
          </a:scene3d>
        </p:spPr>
        <p:txBody>
          <a:bodyPr vert="vert270" wrap="none" rtlCol="0">
            <a:spAutoFit/>
          </a:bodyPr>
          <a:lstStyle/>
          <a:p>
            <a:pPr algn="ctr"/>
            <a:r>
              <a:rPr lang="de-DE" sz="800" b="1" dirty="0" err="1">
                <a:latin typeface="Arial" pitchFamily="34" charset="0"/>
                <a:cs typeface="Arial" pitchFamily="34" charset="0"/>
              </a:rPr>
              <a:t>Length</a:t>
            </a:r>
            <a:r>
              <a:rPr lang="de-DE" sz="8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800" b="1" dirty="0" err="1">
                <a:latin typeface="Arial" pitchFamily="34" charset="0"/>
                <a:cs typeface="Arial" pitchFamily="34" charset="0"/>
              </a:rPr>
              <a:t>of</a:t>
            </a:r>
            <a:r>
              <a:rPr lang="de-DE" sz="8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800" b="1" dirty="0" err="1">
                <a:latin typeface="Arial" pitchFamily="34" charset="0"/>
                <a:cs typeface="Arial" pitchFamily="34" charset="0"/>
              </a:rPr>
              <a:t>the</a:t>
            </a:r>
            <a:r>
              <a:rPr lang="de-DE" sz="8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800" b="1" dirty="0" err="1">
                <a:latin typeface="Arial" pitchFamily="34" charset="0"/>
                <a:cs typeface="Arial" pitchFamily="34" charset="0"/>
              </a:rPr>
              <a:t>epithelial</a:t>
            </a:r>
            <a:r>
              <a:rPr lang="de-DE" sz="8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800" b="1" dirty="0" err="1">
                <a:latin typeface="Arial" pitchFamily="34" charset="0"/>
                <a:cs typeface="Arial" pitchFamily="34" charset="0"/>
              </a:rPr>
              <a:t>tongue</a:t>
            </a:r>
            <a:r>
              <a:rPr lang="de-DE" sz="800" b="1" dirty="0">
                <a:latin typeface="Arial" pitchFamily="34" charset="0"/>
                <a:cs typeface="Arial" pitchFamily="34" charset="0"/>
              </a:rPr>
              <a:t> </a:t>
            </a:r>
          </a:p>
          <a:p>
            <a:pPr algn="ctr"/>
            <a:r>
              <a:rPr lang="de-DE" sz="800" b="1" dirty="0">
                <a:latin typeface="Arial" pitchFamily="34" charset="0"/>
                <a:cs typeface="Arial" pitchFamily="34" charset="0"/>
              </a:rPr>
              <a:t>in </a:t>
            </a:r>
            <a:r>
              <a:rPr lang="de-DE" sz="800" b="1" dirty="0" err="1">
                <a:latin typeface="Arial" pitchFamily="34" charset="0"/>
                <a:cs typeface="Arial" pitchFamily="34" charset="0"/>
              </a:rPr>
              <a:t>μm</a:t>
            </a:r>
            <a:endParaRPr lang="de-DE" sz="800" b="1" baseline="30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5" name="Gruppieren 34"/>
          <p:cNvGrpSpPr/>
          <p:nvPr/>
        </p:nvGrpSpPr>
        <p:grpSpPr>
          <a:xfrm>
            <a:off x="1845676" y="6213026"/>
            <a:ext cx="5618476" cy="216024"/>
            <a:chOff x="1977860" y="6258262"/>
            <a:chExt cx="5618476" cy="216024"/>
          </a:xfrm>
        </p:grpSpPr>
        <p:grpSp>
          <p:nvGrpSpPr>
            <p:cNvPr id="36" name="Gruppieren 28"/>
            <p:cNvGrpSpPr/>
            <p:nvPr/>
          </p:nvGrpSpPr>
          <p:grpSpPr>
            <a:xfrm>
              <a:off x="1977860" y="6258306"/>
              <a:ext cx="2594140" cy="215980"/>
              <a:chOff x="4363252" y="6259006"/>
              <a:chExt cx="2594140" cy="215980"/>
            </a:xfrm>
          </p:grpSpPr>
          <p:sp>
            <p:nvSpPr>
              <p:cNvPr id="42" name="Textfeld 41"/>
              <p:cNvSpPr txBox="1"/>
              <p:nvPr/>
            </p:nvSpPr>
            <p:spPr>
              <a:xfrm>
                <a:off x="4509120" y="6259542"/>
                <a:ext cx="122413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pitchFamily="34" charset="0"/>
                    <a:cs typeface="Arial" pitchFamily="34" charset="0"/>
                  </a:rPr>
                  <a:t>Standard </a:t>
                </a:r>
              </a:p>
            </p:txBody>
          </p:sp>
          <p:sp>
            <p:nvSpPr>
              <p:cNvPr id="43" name="Rechteck 42"/>
              <p:cNvSpPr/>
              <p:nvPr/>
            </p:nvSpPr>
            <p:spPr>
              <a:xfrm>
                <a:off x="4363252" y="6289918"/>
                <a:ext cx="144000" cy="14400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44" name="Rechteck 43"/>
              <p:cNvSpPr/>
              <p:nvPr/>
            </p:nvSpPr>
            <p:spPr>
              <a:xfrm>
                <a:off x="5589256" y="6300208"/>
                <a:ext cx="144000" cy="14400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45" name="Textfeld 44"/>
              <p:cNvSpPr txBox="1"/>
              <p:nvPr/>
            </p:nvSpPr>
            <p:spPr>
              <a:xfrm>
                <a:off x="5733256" y="6259006"/>
                <a:ext cx="122413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err="1">
                    <a:latin typeface="Arial" pitchFamily="34" charset="0"/>
                    <a:cs typeface="Arial" pitchFamily="34" charset="0"/>
                  </a:rPr>
                  <a:t>Pathological</a:t>
                </a:r>
                <a:endParaRPr lang="de-DE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7" name="Gruppieren 33"/>
            <p:cNvGrpSpPr/>
            <p:nvPr/>
          </p:nvGrpSpPr>
          <p:grpSpPr>
            <a:xfrm>
              <a:off x="4572000" y="6258262"/>
              <a:ext cx="3024336" cy="215980"/>
              <a:chOff x="4363252" y="6259006"/>
              <a:chExt cx="2594140" cy="215980"/>
            </a:xfrm>
          </p:grpSpPr>
          <p:sp>
            <p:nvSpPr>
              <p:cNvPr id="38" name="Textfeld 37"/>
              <p:cNvSpPr txBox="1"/>
              <p:nvPr/>
            </p:nvSpPr>
            <p:spPr>
              <a:xfrm>
                <a:off x="4509120" y="6259542"/>
                <a:ext cx="122413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pitchFamily="34" charset="0"/>
                    <a:cs typeface="Arial" pitchFamily="34" charset="0"/>
                  </a:rPr>
                  <a:t>Standard + T4 </a:t>
                </a:r>
              </a:p>
            </p:txBody>
          </p:sp>
          <p:sp>
            <p:nvSpPr>
              <p:cNvPr id="39" name="Rechteck 38"/>
              <p:cNvSpPr/>
              <p:nvPr/>
            </p:nvSpPr>
            <p:spPr>
              <a:xfrm>
                <a:off x="4363252" y="6289918"/>
                <a:ext cx="144000" cy="144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40" name="Rechteck 39"/>
              <p:cNvSpPr/>
              <p:nvPr/>
            </p:nvSpPr>
            <p:spPr>
              <a:xfrm>
                <a:off x="5589256" y="6300208"/>
                <a:ext cx="144000" cy="144000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41" name="Textfeld 40"/>
              <p:cNvSpPr txBox="1"/>
              <p:nvPr/>
            </p:nvSpPr>
            <p:spPr>
              <a:xfrm>
                <a:off x="5733256" y="6259006"/>
                <a:ext cx="122413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err="1">
                    <a:latin typeface="Arial" pitchFamily="34" charset="0"/>
                    <a:cs typeface="Arial" pitchFamily="34" charset="0"/>
                  </a:rPr>
                  <a:t>Pathological</a:t>
                </a:r>
                <a:r>
                  <a:rPr lang="de-DE" sz="800" dirty="0">
                    <a:latin typeface="Arial" pitchFamily="34" charset="0"/>
                    <a:cs typeface="Arial" pitchFamily="34" charset="0"/>
                  </a:rPr>
                  <a:t>  + T4</a:t>
                </a:r>
              </a:p>
            </p:txBody>
          </p:sp>
        </p:grpSp>
      </p:grpSp>
      <p:sp>
        <p:nvSpPr>
          <p:cNvPr id="34" name="Textfeld 33"/>
          <p:cNvSpPr txBox="1"/>
          <p:nvPr/>
        </p:nvSpPr>
        <p:spPr>
          <a:xfrm>
            <a:off x="6312025" y="4019456"/>
            <a:ext cx="430887" cy="1504579"/>
          </a:xfrm>
          <a:prstGeom prst="rect">
            <a:avLst/>
          </a:prstGeom>
          <a:noFill/>
          <a:scene3d>
            <a:camera prst="orthographicFront">
              <a:rot lat="0" lon="0" rev="0"/>
            </a:camera>
            <a:lightRig rig="threePt" dir="t"/>
          </a:scene3d>
        </p:spPr>
        <p:txBody>
          <a:bodyPr vert="vert270" wrap="none" rtlCol="0">
            <a:spAutoFit/>
          </a:bodyPr>
          <a:lstStyle/>
          <a:p>
            <a:pPr algn="ctr"/>
            <a:r>
              <a:rPr lang="de-DE" sz="800" b="1" dirty="0">
                <a:latin typeface="Arial" pitchFamily="34" charset="0"/>
                <a:cs typeface="Arial" pitchFamily="34" charset="0"/>
              </a:rPr>
              <a:t>Area </a:t>
            </a:r>
            <a:r>
              <a:rPr lang="de-DE" sz="800" b="1" dirty="0" err="1">
                <a:latin typeface="Arial" pitchFamily="34" charset="0"/>
                <a:cs typeface="Arial" pitchFamily="34" charset="0"/>
              </a:rPr>
              <a:t>of</a:t>
            </a:r>
            <a:r>
              <a:rPr lang="de-DE" sz="8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800" b="1" dirty="0" err="1">
                <a:latin typeface="Arial" pitchFamily="34" charset="0"/>
                <a:cs typeface="Arial" pitchFamily="34" charset="0"/>
              </a:rPr>
              <a:t>the</a:t>
            </a:r>
            <a:r>
              <a:rPr lang="de-DE" sz="8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800" b="1" dirty="0" err="1">
                <a:latin typeface="Arial" pitchFamily="34" charset="0"/>
                <a:cs typeface="Arial" pitchFamily="34" charset="0"/>
              </a:rPr>
              <a:t>epithelial</a:t>
            </a:r>
            <a:r>
              <a:rPr lang="de-DE" sz="8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800" b="1" dirty="0" err="1">
                <a:latin typeface="Arial" pitchFamily="34" charset="0"/>
                <a:cs typeface="Arial" pitchFamily="34" charset="0"/>
              </a:rPr>
              <a:t>tongue</a:t>
            </a:r>
            <a:r>
              <a:rPr lang="de-DE" sz="800" b="1" dirty="0">
                <a:latin typeface="Arial" pitchFamily="34" charset="0"/>
                <a:cs typeface="Arial" pitchFamily="34" charset="0"/>
              </a:rPr>
              <a:t> </a:t>
            </a:r>
          </a:p>
          <a:p>
            <a:pPr algn="ctr"/>
            <a:r>
              <a:rPr lang="de-DE" sz="800" b="1" dirty="0">
                <a:latin typeface="Arial" pitchFamily="34" charset="0"/>
                <a:cs typeface="Arial" pitchFamily="34" charset="0"/>
              </a:rPr>
              <a:t>in </a:t>
            </a:r>
            <a:r>
              <a:rPr lang="el-GR" sz="800" b="1" dirty="0">
                <a:latin typeface="Arial" pitchFamily="34" charset="0"/>
                <a:cs typeface="Arial" pitchFamily="34" charset="0"/>
              </a:rPr>
              <a:t>μ</a:t>
            </a:r>
            <a:r>
              <a:rPr lang="de-DE" sz="800" b="1" dirty="0">
                <a:latin typeface="Arial" pitchFamily="34" charset="0"/>
                <a:cs typeface="Arial" pitchFamily="34" charset="0"/>
              </a:rPr>
              <a:t>m</a:t>
            </a:r>
            <a:r>
              <a:rPr lang="de-DE" sz="800" b="1" baseline="30000" dirty="0">
                <a:latin typeface="Arial" pitchFamily="34" charset="0"/>
                <a:cs typeface="Arial" pitchFamily="34" charset="0"/>
              </a:rPr>
              <a:t>2</a:t>
            </a:r>
          </a:p>
        </p:txBody>
      </p:sp>
      <p:sp>
        <p:nvSpPr>
          <p:cNvPr id="47" name="Textfeld 46"/>
          <p:cNvSpPr txBox="1"/>
          <p:nvPr/>
        </p:nvSpPr>
        <p:spPr>
          <a:xfrm>
            <a:off x="7104112" y="267676"/>
            <a:ext cx="1728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Dyskeratosis</a:t>
            </a:r>
            <a:endParaRPr lang="de-DE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2495600" y="287421"/>
            <a:ext cx="1728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itchFamily="34" charset="0"/>
                <a:cs typeface="Arial" pitchFamily="34" charset="0"/>
              </a:rPr>
              <a:t>Split </a:t>
            </a:r>
            <a:r>
              <a:rPr lang="de-DE" sz="1400" b="1" dirty="0" err="1">
                <a:latin typeface="Arial" pitchFamily="34" charset="0"/>
                <a:cs typeface="Arial" pitchFamily="34" charset="0"/>
              </a:rPr>
              <a:t>formation</a:t>
            </a:r>
            <a:endParaRPr lang="de-DE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2495600" y="3292012"/>
            <a:ext cx="29523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>
                <a:latin typeface="Arial" pitchFamily="34" charset="0"/>
                <a:cs typeface="Arial" pitchFamily="34" charset="0"/>
              </a:rPr>
              <a:t>Length</a:t>
            </a:r>
            <a:r>
              <a:rPr lang="de-DE" sz="1400" b="1" dirty="0">
                <a:latin typeface="Arial" pitchFamily="34" charset="0"/>
                <a:cs typeface="Arial" pitchFamily="34" charset="0"/>
              </a:rPr>
              <a:t> of </a:t>
            </a:r>
            <a:r>
              <a:rPr lang="de-DE" sz="1400" b="1" dirty="0" err="1">
                <a:latin typeface="Arial" pitchFamily="34" charset="0"/>
                <a:cs typeface="Arial" pitchFamily="34" charset="0"/>
              </a:rPr>
              <a:t>the</a:t>
            </a:r>
            <a:r>
              <a:rPr lang="de-DE" sz="14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b="1" dirty="0" err="1">
                <a:latin typeface="Arial" pitchFamily="34" charset="0"/>
                <a:cs typeface="Arial" pitchFamily="34" charset="0"/>
              </a:rPr>
              <a:t>epithelial</a:t>
            </a:r>
            <a:r>
              <a:rPr lang="de-DE" sz="14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b="1" dirty="0" err="1">
                <a:latin typeface="Arial" pitchFamily="34" charset="0"/>
                <a:cs typeface="Arial" pitchFamily="34" charset="0"/>
              </a:rPr>
              <a:t>tongue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7032104" y="3311757"/>
            <a:ext cx="27363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itchFamily="34" charset="0"/>
                <a:cs typeface="Arial" pitchFamily="34" charset="0"/>
              </a:rPr>
              <a:t>Area of </a:t>
            </a:r>
            <a:r>
              <a:rPr lang="de-DE" sz="1400" b="1" dirty="0" err="1">
                <a:latin typeface="Arial" pitchFamily="34" charset="0"/>
                <a:cs typeface="Arial" pitchFamily="34" charset="0"/>
              </a:rPr>
              <a:t>the</a:t>
            </a:r>
            <a:r>
              <a:rPr lang="de-DE" sz="14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b="1" dirty="0" err="1">
                <a:latin typeface="Arial" pitchFamily="34" charset="0"/>
                <a:cs typeface="Arial" pitchFamily="34" charset="0"/>
              </a:rPr>
              <a:t>epithelial</a:t>
            </a:r>
            <a:r>
              <a:rPr lang="de-DE" sz="14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b="1" dirty="0" err="1">
                <a:latin typeface="Arial" pitchFamily="34" charset="0"/>
                <a:cs typeface="Arial" pitchFamily="34" charset="0"/>
              </a:rPr>
              <a:t>tongue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35519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9874" y="210958"/>
            <a:ext cx="5989289" cy="1921747"/>
          </a:xfrm>
          <a:prstGeom prst="rect">
            <a:avLst/>
          </a:prstGeom>
        </p:spPr>
      </p:pic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71222060"/>
              </p:ext>
            </p:extLst>
          </p:nvPr>
        </p:nvGraphicFramePr>
        <p:xfrm>
          <a:off x="324793" y="2746204"/>
          <a:ext cx="5759450" cy="1527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Dokument" r:id="rId4" imgW="5759285" imgH="1527392" progId="Word.Document.12">
                  <p:embed/>
                </p:oleObj>
              </mc:Choice>
              <mc:Fallback>
                <p:oleObj name="Dokument" r:id="rId4" imgW="5759285" imgH="1527392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4793" y="2746204"/>
                        <a:ext cx="5759450" cy="1527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" name="Grafik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2087" y="4041040"/>
            <a:ext cx="5762156" cy="263232"/>
          </a:xfrm>
          <a:prstGeom prst="rect">
            <a:avLst/>
          </a:prstGeom>
        </p:spPr>
      </p:pic>
      <p:sp>
        <p:nvSpPr>
          <p:cNvPr id="8" name="Rechteck 7"/>
          <p:cNvSpPr/>
          <p:nvPr/>
        </p:nvSpPr>
        <p:spPr>
          <a:xfrm>
            <a:off x="209874" y="1874678"/>
            <a:ext cx="1976823" cy="27347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1 Primary antibodies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32466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2</Words>
  <Application>Microsoft Office PowerPoint</Application>
  <PresentationFormat>Breitbild</PresentationFormat>
  <Paragraphs>83</Paragraphs>
  <Slides>4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Wingdings</vt:lpstr>
      <vt:lpstr>Office</vt:lpstr>
      <vt:lpstr>Microsoft Word-Dokument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annah Post</dc:creator>
  <cp:lastModifiedBy>kasperkiewicz-m</cp:lastModifiedBy>
  <cp:revision>10</cp:revision>
  <dcterms:created xsi:type="dcterms:W3CDTF">2018-11-08T16:23:57Z</dcterms:created>
  <dcterms:modified xsi:type="dcterms:W3CDTF">2020-02-14T13:55:23Z</dcterms:modified>
</cp:coreProperties>
</file>